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78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00"/>
    <a:srgbClr val="00CCCC"/>
    <a:srgbClr val="FBC69B"/>
    <a:srgbClr val="9CD1E0"/>
    <a:srgbClr val="CC99FF"/>
    <a:srgbClr val="96210A"/>
    <a:srgbClr val="3CD2D2"/>
    <a:srgbClr val="ECBE4A"/>
    <a:srgbClr val="EEA1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6391" autoAdjust="0"/>
    <p:restoredTop sz="98324" autoAdjust="0"/>
  </p:normalViewPr>
  <p:slideViewPr>
    <p:cSldViewPr>
      <p:cViewPr varScale="1">
        <p:scale>
          <a:sx n="109" d="100"/>
          <a:sy n="109" d="100"/>
        </p:scale>
        <p:origin x="2310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5895" cy="7589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WGCNA\Tutorial\Data\Acid-Ma1\1301Genes\geneInfo-1301Power6Cut025-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WGCNA\Tutorial\Data\Acid-Ma1\1301Genes\geneInfo-1301Power6Cut025-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WGCNA\Tutorial\Data\Acid-Ma1\1301Genes\geneInfo-1301Power6Cut025-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WGCNA\Tutorial\Data\Acid-Ma1\1301Genes\geneInfo-1301Power6Cut025-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x27\Documents\AppleGenome\Projects\FruitAcid\RNA_Seq\Yang_Feb-2013\Chapter4\Chapter%204-6-9-2014\geneInfo-1301Power6Cut025-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x27\Documents\AppleGenome\Projects\FruitAcid\RNA_Seq\Yang_Feb-2013\Chapter4\Chapter%204-6-9-2014\geneInfo-1301Power6Cut025-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x27\Documents\AppleGenome\Projects\FruitAcid\RNA_Seq\Yang_Feb-2013\Chapter4\Chapter%204-6-9-2014\geneInfo-1301Power6Cut025-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x27\Documents\AppleGenome\Projects\FruitAcid\RNA_Seq\Yang_Feb-2013\Chapter4\Chapter%204-6-9-2014\geneInfo-1301Power6Cut025-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geneInfo-1301Power6Cut025-2-cop'!$AF$1</c:f>
              <c:strCache>
                <c:ptCount val="1"/>
                <c:pt idx="0">
                  <c:v>ABS-MM.black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'geneInfo-1301Power6Cut025-2-cop'!$AF$2:$AF$98</c:f>
              <c:numCache>
                <c:formatCode>General</c:formatCode>
                <c:ptCount val="97"/>
                <c:pt idx="0">
                  <c:v>0.83480596170166499</c:v>
                </c:pt>
                <c:pt idx="1">
                  <c:v>0.82336100144796398</c:v>
                </c:pt>
                <c:pt idx="2">
                  <c:v>0.77335520392229196</c:v>
                </c:pt>
                <c:pt idx="3">
                  <c:v>0.65391542282308002</c:v>
                </c:pt>
                <c:pt idx="4">
                  <c:v>0.854268599448338</c:v>
                </c:pt>
                <c:pt idx="5">
                  <c:v>0.81134829498537997</c:v>
                </c:pt>
                <c:pt idx="6">
                  <c:v>0.75118037136662796</c:v>
                </c:pt>
                <c:pt idx="7">
                  <c:v>0.78237569534386897</c:v>
                </c:pt>
                <c:pt idx="8">
                  <c:v>0.86500570422258205</c:v>
                </c:pt>
                <c:pt idx="9">
                  <c:v>0.78886406676768395</c:v>
                </c:pt>
                <c:pt idx="10">
                  <c:v>0.83543993079992696</c:v>
                </c:pt>
                <c:pt idx="11">
                  <c:v>0.77714492569865801</c:v>
                </c:pt>
                <c:pt idx="12">
                  <c:v>0.63006485098946896</c:v>
                </c:pt>
                <c:pt idx="13">
                  <c:v>0.64863221501385704</c:v>
                </c:pt>
                <c:pt idx="14">
                  <c:v>0.75109720954944204</c:v>
                </c:pt>
                <c:pt idx="15">
                  <c:v>0.93262548198523998</c:v>
                </c:pt>
                <c:pt idx="16">
                  <c:v>0.82267112944275</c:v>
                </c:pt>
                <c:pt idx="17">
                  <c:v>0.857878387855327</c:v>
                </c:pt>
                <c:pt idx="18">
                  <c:v>0.67430227692276401</c:v>
                </c:pt>
                <c:pt idx="19">
                  <c:v>0.84615483255202695</c:v>
                </c:pt>
                <c:pt idx="20">
                  <c:v>0.839424137897409</c:v>
                </c:pt>
                <c:pt idx="21">
                  <c:v>0.75522342561967304</c:v>
                </c:pt>
                <c:pt idx="22">
                  <c:v>0.75698436044486395</c:v>
                </c:pt>
                <c:pt idx="23">
                  <c:v>0.76923955906803498</c:v>
                </c:pt>
                <c:pt idx="24">
                  <c:v>0.81752216982802395</c:v>
                </c:pt>
                <c:pt idx="25">
                  <c:v>0.80007643577221899</c:v>
                </c:pt>
                <c:pt idx="26">
                  <c:v>0.71937085020886404</c:v>
                </c:pt>
                <c:pt idx="27">
                  <c:v>0.67601804090467299</c:v>
                </c:pt>
                <c:pt idx="28">
                  <c:v>0.73809259044058795</c:v>
                </c:pt>
                <c:pt idx="29">
                  <c:v>0.77148088792078595</c:v>
                </c:pt>
                <c:pt idx="30">
                  <c:v>0.84330978219792396</c:v>
                </c:pt>
                <c:pt idx="31">
                  <c:v>0.73267604842122502</c:v>
                </c:pt>
                <c:pt idx="32">
                  <c:v>0.80665875119471098</c:v>
                </c:pt>
                <c:pt idx="33">
                  <c:v>0.83804475307584703</c:v>
                </c:pt>
                <c:pt idx="34">
                  <c:v>0.77418392699754801</c:v>
                </c:pt>
                <c:pt idx="35">
                  <c:v>0.91557273170077202</c:v>
                </c:pt>
                <c:pt idx="36">
                  <c:v>0.66972373161102206</c:v>
                </c:pt>
                <c:pt idx="37">
                  <c:v>0.83324014228002197</c:v>
                </c:pt>
                <c:pt idx="38">
                  <c:v>0.57360616346675197</c:v>
                </c:pt>
                <c:pt idx="39">
                  <c:v>0.86702475284177905</c:v>
                </c:pt>
                <c:pt idx="40">
                  <c:v>0.59576453437579402</c:v>
                </c:pt>
                <c:pt idx="41">
                  <c:v>0.92079292137976998</c:v>
                </c:pt>
                <c:pt idx="42">
                  <c:v>0.88845058989009695</c:v>
                </c:pt>
                <c:pt idx="43">
                  <c:v>0.78751072200085503</c:v>
                </c:pt>
                <c:pt idx="44">
                  <c:v>0.93813073553991799</c:v>
                </c:pt>
                <c:pt idx="45">
                  <c:v>0.83109563453297097</c:v>
                </c:pt>
                <c:pt idx="46">
                  <c:v>0.526718226779891</c:v>
                </c:pt>
                <c:pt idx="47">
                  <c:v>0.92161693279860901</c:v>
                </c:pt>
                <c:pt idx="48">
                  <c:v>0.77118385502280895</c:v>
                </c:pt>
                <c:pt idx="49">
                  <c:v>0.60049789897542105</c:v>
                </c:pt>
                <c:pt idx="50">
                  <c:v>0.80183549398004905</c:v>
                </c:pt>
                <c:pt idx="51">
                  <c:v>0.74699808570709103</c:v>
                </c:pt>
                <c:pt idx="52">
                  <c:v>0.67747386865756298</c:v>
                </c:pt>
                <c:pt idx="53">
                  <c:v>0.88423485112974698</c:v>
                </c:pt>
                <c:pt idx="54">
                  <c:v>0.61117532379425499</c:v>
                </c:pt>
                <c:pt idx="55">
                  <c:v>0.858257188174262</c:v>
                </c:pt>
                <c:pt idx="56">
                  <c:v>0.64826043822548696</c:v>
                </c:pt>
                <c:pt idx="57">
                  <c:v>0.75643453799302496</c:v>
                </c:pt>
                <c:pt idx="58">
                  <c:v>0.57227627093571498</c:v>
                </c:pt>
                <c:pt idx="59">
                  <c:v>0.60327712276331502</c:v>
                </c:pt>
                <c:pt idx="60">
                  <c:v>0.75479293762026201</c:v>
                </c:pt>
                <c:pt idx="61">
                  <c:v>0.824594950870844</c:v>
                </c:pt>
                <c:pt idx="62">
                  <c:v>0.79718272038153104</c:v>
                </c:pt>
                <c:pt idx="63">
                  <c:v>0.77506946554387501</c:v>
                </c:pt>
                <c:pt idx="64">
                  <c:v>0.73725187181629703</c:v>
                </c:pt>
                <c:pt idx="65">
                  <c:v>0.49458048900011697</c:v>
                </c:pt>
                <c:pt idx="66">
                  <c:v>0.74402050216537496</c:v>
                </c:pt>
                <c:pt idx="67">
                  <c:v>0.74164525570548401</c:v>
                </c:pt>
                <c:pt idx="68">
                  <c:v>0.82181282850007698</c:v>
                </c:pt>
                <c:pt idx="69">
                  <c:v>0.93280484466868796</c:v>
                </c:pt>
                <c:pt idx="70">
                  <c:v>0.58126797887835202</c:v>
                </c:pt>
                <c:pt idx="71">
                  <c:v>0.67762528900849195</c:v>
                </c:pt>
                <c:pt idx="72">
                  <c:v>0.85492137925893397</c:v>
                </c:pt>
                <c:pt idx="73">
                  <c:v>0.81791459320847404</c:v>
                </c:pt>
                <c:pt idx="74">
                  <c:v>0.87541206187848397</c:v>
                </c:pt>
                <c:pt idx="75">
                  <c:v>0.50348922876968805</c:v>
                </c:pt>
                <c:pt idx="76">
                  <c:v>0.71771286008649504</c:v>
                </c:pt>
                <c:pt idx="77">
                  <c:v>0.85063047384823698</c:v>
                </c:pt>
                <c:pt idx="78">
                  <c:v>0.80579059327120806</c:v>
                </c:pt>
                <c:pt idx="79">
                  <c:v>0.83549009242718797</c:v>
                </c:pt>
                <c:pt idx="80">
                  <c:v>0.79950337459796395</c:v>
                </c:pt>
                <c:pt idx="81">
                  <c:v>0.819767675111717</c:v>
                </c:pt>
                <c:pt idx="82">
                  <c:v>0.82296820639963797</c:v>
                </c:pt>
                <c:pt idx="83">
                  <c:v>0.71704239261925895</c:v>
                </c:pt>
                <c:pt idx="84">
                  <c:v>0.77699381584705596</c:v>
                </c:pt>
                <c:pt idx="85">
                  <c:v>0.59064545078782404</c:v>
                </c:pt>
                <c:pt idx="86">
                  <c:v>0.83152124630989799</c:v>
                </c:pt>
                <c:pt idx="87">
                  <c:v>0.45787315393749001</c:v>
                </c:pt>
                <c:pt idx="88">
                  <c:v>0.213694262061639</c:v>
                </c:pt>
                <c:pt idx="89">
                  <c:v>0.71252845512648799</c:v>
                </c:pt>
                <c:pt idx="90">
                  <c:v>0.64028115320713797</c:v>
                </c:pt>
                <c:pt idx="91">
                  <c:v>0.64345118273389001</c:v>
                </c:pt>
                <c:pt idx="92">
                  <c:v>0.48948611730820202</c:v>
                </c:pt>
                <c:pt idx="93">
                  <c:v>0.757049987146449</c:v>
                </c:pt>
                <c:pt idx="94">
                  <c:v>0.26195022923268202</c:v>
                </c:pt>
                <c:pt idx="95">
                  <c:v>0.25242449720791899</c:v>
                </c:pt>
                <c:pt idx="96">
                  <c:v>0.50059595748124297</c:v>
                </c:pt>
              </c:numCache>
            </c:numRef>
          </c:xVal>
          <c:yVal>
            <c:numRef>
              <c:f>'geneInfo-1301Power6Cut025-2-cop'!$F$2:$F$98</c:f>
              <c:numCache>
                <c:formatCode>General</c:formatCode>
                <c:ptCount val="97"/>
                <c:pt idx="0">
                  <c:v>0.86359461686936401</c:v>
                </c:pt>
                <c:pt idx="1">
                  <c:v>0.813390543945541</c:v>
                </c:pt>
                <c:pt idx="2">
                  <c:v>0.80677631760853097</c:v>
                </c:pt>
                <c:pt idx="3">
                  <c:v>0.78054294530317503</c:v>
                </c:pt>
                <c:pt idx="4">
                  <c:v>0.77491106302492796</c:v>
                </c:pt>
                <c:pt idx="5">
                  <c:v>0.75545850258348402</c:v>
                </c:pt>
                <c:pt idx="6">
                  <c:v>0.72001779325361903</c:v>
                </c:pt>
                <c:pt idx="7">
                  <c:v>0.70786663085795998</c:v>
                </c:pt>
                <c:pt idx="8">
                  <c:v>0.69749263440999598</c:v>
                </c:pt>
                <c:pt idx="9">
                  <c:v>0.69197016687477697</c:v>
                </c:pt>
                <c:pt idx="10">
                  <c:v>0.69073656146033102</c:v>
                </c:pt>
                <c:pt idx="11">
                  <c:v>0.68423972517468101</c:v>
                </c:pt>
                <c:pt idx="12">
                  <c:v>0.67910236630395604</c:v>
                </c:pt>
                <c:pt idx="13">
                  <c:v>0.67236353027294304</c:v>
                </c:pt>
                <c:pt idx="14">
                  <c:v>0.66698506942138602</c:v>
                </c:pt>
                <c:pt idx="15">
                  <c:v>0.66241903420780202</c:v>
                </c:pt>
                <c:pt idx="16">
                  <c:v>0.66089363038183002</c:v>
                </c:pt>
                <c:pt idx="17">
                  <c:v>0.646469268227161</c:v>
                </c:pt>
                <c:pt idx="18">
                  <c:v>0.64159430925963101</c:v>
                </c:pt>
                <c:pt idx="19">
                  <c:v>0.63010602137419602</c:v>
                </c:pt>
                <c:pt idx="20">
                  <c:v>0.629210706617508</c:v>
                </c:pt>
                <c:pt idx="21">
                  <c:v>0.61911391631540802</c:v>
                </c:pt>
                <c:pt idx="22">
                  <c:v>0.61498095202382597</c:v>
                </c:pt>
                <c:pt idx="23">
                  <c:v>0.61341515914112998</c:v>
                </c:pt>
                <c:pt idx="24">
                  <c:v>0.61059829149343103</c:v>
                </c:pt>
                <c:pt idx="25">
                  <c:v>0.60194217899400804</c:v>
                </c:pt>
                <c:pt idx="26">
                  <c:v>0.59888057446042997</c:v>
                </c:pt>
                <c:pt idx="27">
                  <c:v>0.58785982854159102</c:v>
                </c:pt>
                <c:pt idx="28">
                  <c:v>0.58718931650466999</c:v>
                </c:pt>
                <c:pt idx="29">
                  <c:v>0.58698502110974204</c:v>
                </c:pt>
                <c:pt idx="30">
                  <c:v>0.58130532953723502</c:v>
                </c:pt>
                <c:pt idx="31">
                  <c:v>0.57475400358265505</c:v>
                </c:pt>
                <c:pt idx="32">
                  <c:v>0.57149037405853897</c:v>
                </c:pt>
                <c:pt idx="33">
                  <c:v>0.57108625893476395</c:v>
                </c:pt>
                <c:pt idx="34">
                  <c:v>0.56940879660049903</c:v>
                </c:pt>
                <c:pt idx="35">
                  <c:v>0.56907952778849202</c:v>
                </c:pt>
                <c:pt idx="36">
                  <c:v>0.56494634555478995</c:v>
                </c:pt>
                <c:pt idx="37">
                  <c:v>0.55784450157097498</c:v>
                </c:pt>
                <c:pt idx="38">
                  <c:v>0.54624970443350096</c:v>
                </c:pt>
                <c:pt idx="39">
                  <c:v>0.54440375492163795</c:v>
                </c:pt>
                <c:pt idx="40">
                  <c:v>0.53599226693652702</c:v>
                </c:pt>
                <c:pt idx="41">
                  <c:v>0.53467774598455997</c:v>
                </c:pt>
                <c:pt idx="42">
                  <c:v>0.52383796354498002</c:v>
                </c:pt>
                <c:pt idx="43">
                  <c:v>0.52122203352829399</c:v>
                </c:pt>
                <c:pt idx="44">
                  <c:v>0.51894494651919898</c:v>
                </c:pt>
                <c:pt idx="45">
                  <c:v>0.51872287935235095</c:v>
                </c:pt>
                <c:pt idx="46">
                  <c:v>0.51559362087648197</c:v>
                </c:pt>
                <c:pt idx="47">
                  <c:v>0.51027528507040798</c:v>
                </c:pt>
                <c:pt idx="48">
                  <c:v>0.48989826970364198</c:v>
                </c:pt>
                <c:pt idx="49">
                  <c:v>0.488912980082709</c:v>
                </c:pt>
                <c:pt idx="50">
                  <c:v>0.48124402036734898</c:v>
                </c:pt>
                <c:pt idx="51">
                  <c:v>0.46860589947778702</c:v>
                </c:pt>
                <c:pt idx="52">
                  <c:v>0.46182848307583901</c:v>
                </c:pt>
                <c:pt idx="53">
                  <c:v>0.46013759271165999</c:v>
                </c:pt>
                <c:pt idx="54">
                  <c:v>0.45738091785606899</c:v>
                </c:pt>
                <c:pt idx="55">
                  <c:v>0.45254698462378701</c:v>
                </c:pt>
                <c:pt idx="56">
                  <c:v>0.45139456869850503</c:v>
                </c:pt>
                <c:pt idx="57">
                  <c:v>0.45113060917251802</c:v>
                </c:pt>
                <c:pt idx="58">
                  <c:v>0.44763452565899903</c:v>
                </c:pt>
                <c:pt idx="59">
                  <c:v>0.44564688602596603</c:v>
                </c:pt>
                <c:pt idx="60">
                  <c:v>0.445271822029423</c:v>
                </c:pt>
                <c:pt idx="61">
                  <c:v>0.442903604611813</c:v>
                </c:pt>
                <c:pt idx="62">
                  <c:v>0.43851911416924</c:v>
                </c:pt>
                <c:pt idx="63">
                  <c:v>0.43549018548157198</c:v>
                </c:pt>
                <c:pt idx="64">
                  <c:v>0.42734911578310297</c:v>
                </c:pt>
                <c:pt idx="65">
                  <c:v>0.42626727471660802</c:v>
                </c:pt>
                <c:pt idx="66">
                  <c:v>0.42135788568032601</c:v>
                </c:pt>
                <c:pt idx="67">
                  <c:v>0.41073306075813198</c:v>
                </c:pt>
                <c:pt idx="68">
                  <c:v>0.40869457478020399</c:v>
                </c:pt>
                <c:pt idx="69">
                  <c:v>0.40183284266094799</c:v>
                </c:pt>
                <c:pt idx="70">
                  <c:v>0.39611109233456698</c:v>
                </c:pt>
                <c:pt idx="71">
                  <c:v>0.39015216591604102</c:v>
                </c:pt>
                <c:pt idx="72">
                  <c:v>0.37783517788483301</c:v>
                </c:pt>
                <c:pt idx="73">
                  <c:v>0.37776790182695702</c:v>
                </c:pt>
                <c:pt idx="74">
                  <c:v>0.36965082231806201</c:v>
                </c:pt>
                <c:pt idx="75">
                  <c:v>0.35179239638327398</c:v>
                </c:pt>
                <c:pt idx="76">
                  <c:v>0.35160282952401301</c:v>
                </c:pt>
                <c:pt idx="77">
                  <c:v>0.34377176396661302</c:v>
                </c:pt>
                <c:pt idx="78">
                  <c:v>0.34287277363542601</c:v>
                </c:pt>
                <c:pt idx="79">
                  <c:v>0.34232577401029501</c:v>
                </c:pt>
                <c:pt idx="80">
                  <c:v>0.34077569140299602</c:v>
                </c:pt>
                <c:pt idx="81">
                  <c:v>0.33652934205852802</c:v>
                </c:pt>
                <c:pt idx="82">
                  <c:v>0.33422978599542702</c:v>
                </c:pt>
                <c:pt idx="83">
                  <c:v>0.31639831673129798</c:v>
                </c:pt>
                <c:pt idx="84">
                  <c:v>0.31132739651981101</c:v>
                </c:pt>
                <c:pt idx="85">
                  <c:v>0.29927858893407999</c:v>
                </c:pt>
                <c:pt idx="86">
                  <c:v>0.28942069306243101</c:v>
                </c:pt>
                <c:pt idx="87">
                  <c:v>0.26539079898077</c:v>
                </c:pt>
                <c:pt idx="88">
                  <c:v>0.24822202184316999</c:v>
                </c:pt>
                <c:pt idx="89">
                  <c:v>0.21352269681365199</c:v>
                </c:pt>
                <c:pt idx="90">
                  <c:v>0.19490837838368899</c:v>
                </c:pt>
                <c:pt idx="91">
                  <c:v>0.18542042484628399</c:v>
                </c:pt>
                <c:pt idx="92">
                  <c:v>0.156792106046691</c:v>
                </c:pt>
                <c:pt idx="93">
                  <c:v>0.14960135733982799</c:v>
                </c:pt>
                <c:pt idx="94">
                  <c:v>5.9295539679325403E-2</c:v>
                </c:pt>
                <c:pt idx="95">
                  <c:v>4.6725644825263701E-2</c:v>
                </c:pt>
                <c:pt idx="96">
                  <c:v>1.79596998126186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150200"/>
        <c:axId val="334789016"/>
      </c:scatterChart>
      <c:valAx>
        <c:axId val="335150200"/>
        <c:scaling>
          <c:orientation val="minMax"/>
          <c:max val="1"/>
          <c:min val="0.2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Module membership in Black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89016"/>
        <c:crosses val="autoZero"/>
        <c:crossBetween val="midCat"/>
      </c:valAx>
      <c:valAx>
        <c:axId val="334789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Gene significance for malate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5150200"/>
        <c:crossesAt val="0"/>
        <c:crossBetween val="midCat"/>
      </c:valAx>
      <c:spPr>
        <a:solidFill>
          <a:schemeClr val="bg1">
            <a:lumMod val="50000"/>
          </a:schemeClr>
        </a:solidFill>
        <a:ln w="3175"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geneInfo-1301Power6Cut025-2-cop'!$AH$1</c:f>
              <c:strCache>
                <c:ptCount val="1"/>
                <c:pt idx="0">
                  <c:v>ABS-MM.blue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rgbClr val="0033CC"/>
                </a:solidFill>
              </a:ln>
            </c:spPr>
          </c:marker>
          <c:xVal>
            <c:numRef>
              <c:f>'geneInfo-1301Power6Cut025-2-cop'!$AH$99:$AH$293</c:f>
              <c:numCache>
                <c:formatCode>General</c:formatCode>
                <c:ptCount val="195"/>
                <c:pt idx="0">
                  <c:v>0.71735675832087897</c:v>
                </c:pt>
                <c:pt idx="1">
                  <c:v>0.71590162238979105</c:v>
                </c:pt>
                <c:pt idx="2">
                  <c:v>0.82642247320555695</c:v>
                </c:pt>
                <c:pt idx="3">
                  <c:v>0.73105865884269305</c:v>
                </c:pt>
                <c:pt idx="4">
                  <c:v>0.67283137761464196</c:v>
                </c:pt>
                <c:pt idx="5">
                  <c:v>0.66406363068901497</c:v>
                </c:pt>
                <c:pt idx="6">
                  <c:v>0.58176190842826003</c:v>
                </c:pt>
                <c:pt idx="7">
                  <c:v>0.67766323058903499</c:v>
                </c:pt>
                <c:pt idx="8">
                  <c:v>0.79140461725912503</c:v>
                </c:pt>
                <c:pt idx="9">
                  <c:v>0.732156431231755</c:v>
                </c:pt>
                <c:pt idx="10">
                  <c:v>0.64821642776074495</c:v>
                </c:pt>
                <c:pt idx="11">
                  <c:v>0.72819935962320803</c:v>
                </c:pt>
                <c:pt idx="12">
                  <c:v>0.54660398103713304</c:v>
                </c:pt>
                <c:pt idx="13">
                  <c:v>0.52309132178764595</c:v>
                </c:pt>
                <c:pt idx="14">
                  <c:v>0.66136905204626295</c:v>
                </c:pt>
                <c:pt idx="15">
                  <c:v>0.733864994846543</c:v>
                </c:pt>
                <c:pt idx="16">
                  <c:v>0.71078905346658705</c:v>
                </c:pt>
                <c:pt idx="17">
                  <c:v>0.60412360119782704</c:v>
                </c:pt>
                <c:pt idx="18">
                  <c:v>0.66363171414036404</c:v>
                </c:pt>
                <c:pt idx="19">
                  <c:v>0.80973525591551498</c:v>
                </c:pt>
                <c:pt idx="20">
                  <c:v>0.51407013405207902</c:v>
                </c:pt>
                <c:pt idx="21">
                  <c:v>0.86033381987763202</c:v>
                </c:pt>
                <c:pt idx="22">
                  <c:v>0.44474899250466399</c:v>
                </c:pt>
                <c:pt idx="23">
                  <c:v>0.50451789265277802</c:v>
                </c:pt>
                <c:pt idx="24">
                  <c:v>0.56393361104510797</c:v>
                </c:pt>
                <c:pt idx="25">
                  <c:v>0.95015854828619695</c:v>
                </c:pt>
                <c:pt idx="26">
                  <c:v>0.48850142737222302</c:v>
                </c:pt>
                <c:pt idx="27">
                  <c:v>0.76526089474129999</c:v>
                </c:pt>
                <c:pt idx="28">
                  <c:v>0.52948378896974202</c:v>
                </c:pt>
                <c:pt idx="29">
                  <c:v>0.84293277770850905</c:v>
                </c:pt>
                <c:pt idx="30">
                  <c:v>0.89980837544441805</c:v>
                </c:pt>
                <c:pt idx="31">
                  <c:v>0.84293332571853297</c:v>
                </c:pt>
                <c:pt idx="32">
                  <c:v>0.34161046315589899</c:v>
                </c:pt>
                <c:pt idx="33">
                  <c:v>0.715029604925984</c:v>
                </c:pt>
                <c:pt idx="34">
                  <c:v>0.82891299972145005</c:v>
                </c:pt>
                <c:pt idx="35">
                  <c:v>0.64153956662497202</c:v>
                </c:pt>
                <c:pt idx="36">
                  <c:v>0.83231958813345996</c:v>
                </c:pt>
                <c:pt idx="37">
                  <c:v>0.86945980534544698</c:v>
                </c:pt>
                <c:pt idx="38">
                  <c:v>0.62987552796670299</c:v>
                </c:pt>
                <c:pt idx="39">
                  <c:v>0.65832588218017796</c:v>
                </c:pt>
                <c:pt idx="40">
                  <c:v>0.77389327086892101</c:v>
                </c:pt>
                <c:pt idx="41">
                  <c:v>0.90311456839730697</c:v>
                </c:pt>
                <c:pt idx="42">
                  <c:v>0.68628479173178503</c:v>
                </c:pt>
                <c:pt idx="43">
                  <c:v>0.73343646270876794</c:v>
                </c:pt>
                <c:pt idx="44">
                  <c:v>0.69391140287202702</c:v>
                </c:pt>
                <c:pt idx="45">
                  <c:v>0.63754251358094705</c:v>
                </c:pt>
                <c:pt idx="46">
                  <c:v>0.65933555648356001</c:v>
                </c:pt>
                <c:pt idx="47">
                  <c:v>0.74102693048326995</c:v>
                </c:pt>
                <c:pt idx="48">
                  <c:v>0.84666554678542605</c:v>
                </c:pt>
                <c:pt idx="49">
                  <c:v>0.81267962526480098</c:v>
                </c:pt>
                <c:pt idx="50">
                  <c:v>0.40234886739668402</c:v>
                </c:pt>
                <c:pt idx="51">
                  <c:v>0.65464329015732803</c:v>
                </c:pt>
                <c:pt idx="52">
                  <c:v>0.59555710412342699</c:v>
                </c:pt>
                <c:pt idx="53">
                  <c:v>0.357149973287127</c:v>
                </c:pt>
                <c:pt idx="54">
                  <c:v>0.81284050939895802</c:v>
                </c:pt>
                <c:pt idx="55">
                  <c:v>0.888386481244687</c:v>
                </c:pt>
                <c:pt idx="56">
                  <c:v>0.77727804244480903</c:v>
                </c:pt>
                <c:pt idx="57">
                  <c:v>0.91066572996782003</c:v>
                </c:pt>
                <c:pt idx="58">
                  <c:v>0.78391882746839203</c:v>
                </c:pt>
                <c:pt idx="59">
                  <c:v>0.50969566092265495</c:v>
                </c:pt>
                <c:pt idx="60">
                  <c:v>0.92531659843840897</c:v>
                </c:pt>
                <c:pt idx="61">
                  <c:v>0.91013544790369605</c:v>
                </c:pt>
                <c:pt idx="62">
                  <c:v>0.80880767687062005</c:v>
                </c:pt>
                <c:pt idx="63">
                  <c:v>0.60851365177011296</c:v>
                </c:pt>
                <c:pt idx="64">
                  <c:v>0.44867823972485499</c:v>
                </c:pt>
                <c:pt idx="65">
                  <c:v>0.73331999480662902</c:v>
                </c:pt>
                <c:pt idx="66">
                  <c:v>0.90192399328652395</c:v>
                </c:pt>
                <c:pt idx="67">
                  <c:v>0.88967598706598905</c:v>
                </c:pt>
                <c:pt idx="68">
                  <c:v>0.70526368106456705</c:v>
                </c:pt>
                <c:pt idx="69">
                  <c:v>0.93194872969652898</c:v>
                </c:pt>
                <c:pt idx="70">
                  <c:v>0.78852317224381696</c:v>
                </c:pt>
                <c:pt idx="71">
                  <c:v>0.72268525258720195</c:v>
                </c:pt>
                <c:pt idx="72">
                  <c:v>0.76407835183384598</c:v>
                </c:pt>
                <c:pt idx="73">
                  <c:v>0.88264221977269397</c:v>
                </c:pt>
                <c:pt idx="74">
                  <c:v>0.75477898405642196</c:v>
                </c:pt>
                <c:pt idx="75">
                  <c:v>0.82872335306313105</c:v>
                </c:pt>
                <c:pt idx="76">
                  <c:v>0.77933341053512795</c:v>
                </c:pt>
                <c:pt idx="77">
                  <c:v>0.64783403392614203</c:v>
                </c:pt>
                <c:pt idx="78">
                  <c:v>0.86708134564921102</c:v>
                </c:pt>
                <c:pt idx="79">
                  <c:v>0.38832516159431402</c:v>
                </c:pt>
                <c:pt idx="80">
                  <c:v>0.72946688751559197</c:v>
                </c:pt>
                <c:pt idx="81">
                  <c:v>0.85491949063803996</c:v>
                </c:pt>
                <c:pt idx="82">
                  <c:v>0.78576327930012402</c:v>
                </c:pt>
                <c:pt idx="83">
                  <c:v>0.87709494480039396</c:v>
                </c:pt>
                <c:pt idx="84">
                  <c:v>0.78194740942630203</c:v>
                </c:pt>
                <c:pt idx="85">
                  <c:v>0.84186722674145897</c:v>
                </c:pt>
                <c:pt idx="86">
                  <c:v>0.42411992810251797</c:v>
                </c:pt>
                <c:pt idx="87">
                  <c:v>0.69467671859900004</c:v>
                </c:pt>
                <c:pt idx="88">
                  <c:v>0.91759611316651801</c:v>
                </c:pt>
                <c:pt idx="89">
                  <c:v>0.84243367996308505</c:v>
                </c:pt>
                <c:pt idx="90">
                  <c:v>0.78212514298109603</c:v>
                </c:pt>
                <c:pt idx="91">
                  <c:v>0.90108106818342304</c:v>
                </c:pt>
                <c:pt idx="92">
                  <c:v>0.78417695979845203</c:v>
                </c:pt>
                <c:pt idx="93">
                  <c:v>0.71983230024901801</c:v>
                </c:pt>
                <c:pt idx="94">
                  <c:v>0.79758388382562295</c:v>
                </c:pt>
                <c:pt idx="95">
                  <c:v>0.63533971022459201</c:v>
                </c:pt>
                <c:pt idx="96">
                  <c:v>0.80662210238088194</c:v>
                </c:pt>
                <c:pt idx="97">
                  <c:v>0.73438400231846301</c:v>
                </c:pt>
                <c:pt idx="98">
                  <c:v>0.93971935930088402</c:v>
                </c:pt>
                <c:pt idx="99">
                  <c:v>0.60518208008413399</c:v>
                </c:pt>
                <c:pt idx="100">
                  <c:v>0.76416466929369997</c:v>
                </c:pt>
                <c:pt idx="101">
                  <c:v>0.87013745609960202</c:v>
                </c:pt>
                <c:pt idx="102">
                  <c:v>0.62288485888198197</c:v>
                </c:pt>
                <c:pt idx="103">
                  <c:v>0.36609680104676201</c:v>
                </c:pt>
                <c:pt idx="104">
                  <c:v>0.70690118282287295</c:v>
                </c:pt>
                <c:pt idx="105">
                  <c:v>0.90300537310277496</c:v>
                </c:pt>
                <c:pt idx="106">
                  <c:v>0.77254020100093301</c:v>
                </c:pt>
                <c:pt idx="107">
                  <c:v>0.70929874133857596</c:v>
                </c:pt>
                <c:pt idx="108">
                  <c:v>0.795821281918208</c:v>
                </c:pt>
                <c:pt idx="109">
                  <c:v>0.86114559624658504</c:v>
                </c:pt>
                <c:pt idx="110">
                  <c:v>0.57597884421326795</c:v>
                </c:pt>
                <c:pt idx="111">
                  <c:v>0.89440120692591296</c:v>
                </c:pt>
                <c:pt idx="112">
                  <c:v>0.88716487107701203</c:v>
                </c:pt>
                <c:pt idx="113">
                  <c:v>0.85168600895177005</c:v>
                </c:pt>
                <c:pt idx="114">
                  <c:v>0.89987469195315395</c:v>
                </c:pt>
                <c:pt idx="115">
                  <c:v>0.78161820376107505</c:v>
                </c:pt>
                <c:pt idx="116">
                  <c:v>0.93207613034200598</c:v>
                </c:pt>
                <c:pt idx="117">
                  <c:v>0.87920459744386703</c:v>
                </c:pt>
                <c:pt idx="118">
                  <c:v>0.50267336383446204</c:v>
                </c:pt>
                <c:pt idx="119">
                  <c:v>0.85651045134720705</c:v>
                </c:pt>
                <c:pt idx="120">
                  <c:v>0.93748337465506404</c:v>
                </c:pt>
                <c:pt idx="121">
                  <c:v>0.80941145477316001</c:v>
                </c:pt>
                <c:pt idx="122">
                  <c:v>0.72328299842989896</c:v>
                </c:pt>
                <c:pt idx="123">
                  <c:v>0.88769591236132495</c:v>
                </c:pt>
                <c:pt idx="124">
                  <c:v>0.891797636772373</c:v>
                </c:pt>
                <c:pt idx="125">
                  <c:v>0.82363051471470805</c:v>
                </c:pt>
                <c:pt idx="126">
                  <c:v>0.842804141574509</c:v>
                </c:pt>
                <c:pt idx="127">
                  <c:v>0.92427674964005502</c:v>
                </c:pt>
                <c:pt idx="128">
                  <c:v>0.86183549534410397</c:v>
                </c:pt>
                <c:pt idx="129">
                  <c:v>0.54645035829254995</c:v>
                </c:pt>
                <c:pt idx="130">
                  <c:v>0.78433262386479696</c:v>
                </c:pt>
                <c:pt idx="131">
                  <c:v>0.90144539480791697</c:v>
                </c:pt>
                <c:pt idx="132">
                  <c:v>0.765761654899066</c:v>
                </c:pt>
                <c:pt idx="133">
                  <c:v>0.86822056895456601</c:v>
                </c:pt>
                <c:pt idx="134">
                  <c:v>0.76670805942617404</c:v>
                </c:pt>
                <c:pt idx="135">
                  <c:v>0.87665135498846403</c:v>
                </c:pt>
                <c:pt idx="136">
                  <c:v>0.907289110523542</c:v>
                </c:pt>
                <c:pt idx="137">
                  <c:v>0.89563267552631698</c:v>
                </c:pt>
                <c:pt idx="138">
                  <c:v>0.43284754080886401</c:v>
                </c:pt>
                <c:pt idx="139">
                  <c:v>0.83307817738453804</c:v>
                </c:pt>
                <c:pt idx="140">
                  <c:v>0.87116048920734901</c:v>
                </c:pt>
                <c:pt idx="141">
                  <c:v>0.45469474613211602</c:v>
                </c:pt>
                <c:pt idx="142">
                  <c:v>0.715023186408973</c:v>
                </c:pt>
                <c:pt idx="143">
                  <c:v>0.82334315900527499</c:v>
                </c:pt>
                <c:pt idx="144">
                  <c:v>0.74566389654466003</c:v>
                </c:pt>
                <c:pt idx="145">
                  <c:v>0.72060849940120097</c:v>
                </c:pt>
                <c:pt idx="146">
                  <c:v>0.81864540209964598</c:v>
                </c:pt>
                <c:pt idx="147">
                  <c:v>0.72536744338850001</c:v>
                </c:pt>
                <c:pt idx="148">
                  <c:v>0.86054183695157305</c:v>
                </c:pt>
                <c:pt idx="149">
                  <c:v>0.68418111410043203</c:v>
                </c:pt>
                <c:pt idx="150">
                  <c:v>0.76170454466663895</c:v>
                </c:pt>
                <c:pt idx="151">
                  <c:v>0.70504805617424904</c:v>
                </c:pt>
                <c:pt idx="152">
                  <c:v>0.48360606822882901</c:v>
                </c:pt>
                <c:pt idx="153">
                  <c:v>0.70582830615639403</c:v>
                </c:pt>
                <c:pt idx="154">
                  <c:v>0.83346207994463595</c:v>
                </c:pt>
                <c:pt idx="155">
                  <c:v>0.86661318123210496</c:v>
                </c:pt>
                <c:pt idx="156">
                  <c:v>0.50402799374946805</c:v>
                </c:pt>
                <c:pt idx="157">
                  <c:v>0.62750680443483897</c:v>
                </c:pt>
                <c:pt idx="158">
                  <c:v>0.51121263252845495</c:v>
                </c:pt>
                <c:pt idx="159">
                  <c:v>0.63706773577587905</c:v>
                </c:pt>
                <c:pt idx="160">
                  <c:v>0.81401210705076898</c:v>
                </c:pt>
                <c:pt idx="161">
                  <c:v>0.84137682828529203</c:v>
                </c:pt>
                <c:pt idx="162">
                  <c:v>0.763846654044401</c:v>
                </c:pt>
                <c:pt idx="163">
                  <c:v>0.80669145611305404</c:v>
                </c:pt>
                <c:pt idx="164">
                  <c:v>0.85539063211436905</c:v>
                </c:pt>
                <c:pt idx="165">
                  <c:v>0.81065271616307599</c:v>
                </c:pt>
                <c:pt idx="166">
                  <c:v>0.72472124486721701</c:v>
                </c:pt>
                <c:pt idx="167">
                  <c:v>0.592575341989099</c:v>
                </c:pt>
                <c:pt idx="168">
                  <c:v>0.81910271636140597</c:v>
                </c:pt>
                <c:pt idx="169">
                  <c:v>0.489261954887943</c:v>
                </c:pt>
                <c:pt idx="170">
                  <c:v>0.85131489263418103</c:v>
                </c:pt>
                <c:pt idx="171">
                  <c:v>0.73871259245101795</c:v>
                </c:pt>
                <c:pt idx="172">
                  <c:v>0.54943822015298105</c:v>
                </c:pt>
                <c:pt idx="173">
                  <c:v>0.65445386054871002</c:v>
                </c:pt>
                <c:pt idx="174">
                  <c:v>0.49000408114458499</c:v>
                </c:pt>
                <c:pt idx="175">
                  <c:v>0.51713211294400097</c:v>
                </c:pt>
                <c:pt idx="176">
                  <c:v>0.74170271118084097</c:v>
                </c:pt>
                <c:pt idx="177">
                  <c:v>0.575890092526266</c:v>
                </c:pt>
                <c:pt idx="178">
                  <c:v>0.57758423683709603</c:v>
                </c:pt>
                <c:pt idx="179">
                  <c:v>0.74781971269590597</c:v>
                </c:pt>
                <c:pt idx="180">
                  <c:v>0.69569789621778599</c:v>
                </c:pt>
                <c:pt idx="181">
                  <c:v>0.56580498103880295</c:v>
                </c:pt>
                <c:pt idx="182">
                  <c:v>0.65974524920870903</c:v>
                </c:pt>
                <c:pt idx="183">
                  <c:v>0.63966109742145605</c:v>
                </c:pt>
                <c:pt idx="184">
                  <c:v>0.55442490926037202</c:v>
                </c:pt>
                <c:pt idx="185">
                  <c:v>0.51082558144875201</c:v>
                </c:pt>
                <c:pt idx="186">
                  <c:v>0.54602259102254602</c:v>
                </c:pt>
                <c:pt idx="187">
                  <c:v>0.57182221912071896</c:v>
                </c:pt>
                <c:pt idx="188">
                  <c:v>0.37048626270060597</c:v>
                </c:pt>
                <c:pt idx="189">
                  <c:v>0.489130245732396</c:v>
                </c:pt>
                <c:pt idx="190">
                  <c:v>0.525613581618255</c:v>
                </c:pt>
                <c:pt idx="191">
                  <c:v>0.648451817449748</c:v>
                </c:pt>
                <c:pt idx="192">
                  <c:v>0.55030944626023903</c:v>
                </c:pt>
                <c:pt idx="193">
                  <c:v>0.670721699706881</c:v>
                </c:pt>
                <c:pt idx="194">
                  <c:v>0.65674195236685795</c:v>
                </c:pt>
              </c:numCache>
            </c:numRef>
          </c:xVal>
          <c:yVal>
            <c:numRef>
              <c:f>'geneInfo-1301Power6Cut025-2-cop'!$F$99:$F$293</c:f>
              <c:numCache>
                <c:formatCode>General</c:formatCode>
                <c:ptCount val="195"/>
                <c:pt idx="0">
                  <c:v>0.88819904371052605</c:v>
                </c:pt>
                <c:pt idx="1">
                  <c:v>0.87138327449210196</c:v>
                </c:pt>
                <c:pt idx="2">
                  <c:v>0.83154470379186995</c:v>
                </c:pt>
                <c:pt idx="3">
                  <c:v>0.79476377192648195</c:v>
                </c:pt>
                <c:pt idx="4">
                  <c:v>0.78823331173330302</c:v>
                </c:pt>
                <c:pt idx="5">
                  <c:v>0.77570047020444599</c:v>
                </c:pt>
                <c:pt idx="6">
                  <c:v>0.76421803479482697</c:v>
                </c:pt>
                <c:pt idx="7">
                  <c:v>0.75146723523435099</c:v>
                </c:pt>
                <c:pt idx="8">
                  <c:v>0.74793062286522505</c:v>
                </c:pt>
                <c:pt idx="9">
                  <c:v>0.73805419155623098</c:v>
                </c:pt>
                <c:pt idx="10">
                  <c:v>0.73772882761689296</c:v>
                </c:pt>
                <c:pt idx="11">
                  <c:v>0.73016026709948101</c:v>
                </c:pt>
                <c:pt idx="12">
                  <c:v>0.72768706643620895</c:v>
                </c:pt>
                <c:pt idx="13">
                  <c:v>0.72446990214715501</c:v>
                </c:pt>
                <c:pt idx="14">
                  <c:v>0.71350254383508305</c:v>
                </c:pt>
                <c:pt idx="15">
                  <c:v>0.71306206585757803</c:v>
                </c:pt>
                <c:pt idx="16">
                  <c:v>0.71122386256542103</c:v>
                </c:pt>
                <c:pt idx="17">
                  <c:v>0.703970458119894</c:v>
                </c:pt>
                <c:pt idx="18">
                  <c:v>0.69443870459406898</c:v>
                </c:pt>
                <c:pt idx="19">
                  <c:v>0.68489756693142101</c:v>
                </c:pt>
                <c:pt idx="20">
                  <c:v>0.67881983011169</c:v>
                </c:pt>
                <c:pt idx="21">
                  <c:v>0.67236019664214697</c:v>
                </c:pt>
                <c:pt idx="22">
                  <c:v>0.66825624247541904</c:v>
                </c:pt>
                <c:pt idx="23">
                  <c:v>0.66779766462750501</c:v>
                </c:pt>
                <c:pt idx="24">
                  <c:v>0.66728410004982597</c:v>
                </c:pt>
                <c:pt idx="25">
                  <c:v>0.66433462529820297</c:v>
                </c:pt>
                <c:pt idx="26">
                  <c:v>0.66411342887635605</c:v>
                </c:pt>
                <c:pt idx="27">
                  <c:v>0.65822924439115804</c:v>
                </c:pt>
                <c:pt idx="28">
                  <c:v>0.65055624269210299</c:v>
                </c:pt>
                <c:pt idx="29">
                  <c:v>0.64961049941457305</c:v>
                </c:pt>
                <c:pt idx="30">
                  <c:v>0.645381536722899</c:v>
                </c:pt>
                <c:pt idx="31">
                  <c:v>0.64409310697587496</c:v>
                </c:pt>
                <c:pt idx="32">
                  <c:v>0.63997691798791401</c:v>
                </c:pt>
                <c:pt idx="33">
                  <c:v>0.63786151912927302</c:v>
                </c:pt>
                <c:pt idx="34">
                  <c:v>0.63112307605879103</c:v>
                </c:pt>
                <c:pt idx="35">
                  <c:v>0.62975283582414798</c:v>
                </c:pt>
                <c:pt idx="36">
                  <c:v>0.62675765595564303</c:v>
                </c:pt>
                <c:pt idx="37">
                  <c:v>0.622398747219159</c:v>
                </c:pt>
                <c:pt idx="38">
                  <c:v>0.61994519559153205</c:v>
                </c:pt>
                <c:pt idx="39">
                  <c:v>0.61853490025397295</c:v>
                </c:pt>
                <c:pt idx="40">
                  <c:v>0.61205350035335204</c:v>
                </c:pt>
                <c:pt idx="41">
                  <c:v>0.60908402621985402</c:v>
                </c:pt>
                <c:pt idx="42">
                  <c:v>0.60906123057017603</c:v>
                </c:pt>
                <c:pt idx="43">
                  <c:v>0.60724208058663798</c:v>
                </c:pt>
                <c:pt idx="44">
                  <c:v>0.60433133647408599</c:v>
                </c:pt>
                <c:pt idx="45">
                  <c:v>0.58751743446631799</c:v>
                </c:pt>
                <c:pt idx="46">
                  <c:v>0.586829629398536</c:v>
                </c:pt>
                <c:pt idx="47">
                  <c:v>0.575515458323405</c:v>
                </c:pt>
                <c:pt idx="48">
                  <c:v>0.57083369061273004</c:v>
                </c:pt>
                <c:pt idx="49">
                  <c:v>0.56939091503196604</c:v>
                </c:pt>
                <c:pt idx="50">
                  <c:v>0.56546147593893503</c:v>
                </c:pt>
                <c:pt idx="51">
                  <c:v>0.56359824938825898</c:v>
                </c:pt>
                <c:pt idx="52">
                  <c:v>0.56328605366580997</c:v>
                </c:pt>
                <c:pt idx="53">
                  <c:v>0.55799096494607403</c:v>
                </c:pt>
                <c:pt idx="54">
                  <c:v>0.55741788186771501</c:v>
                </c:pt>
                <c:pt idx="55">
                  <c:v>0.55632509640795103</c:v>
                </c:pt>
                <c:pt idx="56">
                  <c:v>0.55400130736835596</c:v>
                </c:pt>
                <c:pt idx="57">
                  <c:v>0.55022030994670101</c:v>
                </c:pt>
                <c:pt idx="58">
                  <c:v>0.54803869750638801</c:v>
                </c:pt>
                <c:pt idx="59">
                  <c:v>0.54775448205014099</c:v>
                </c:pt>
                <c:pt idx="60">
                  <c:v>0.54711780764922002</c:v>
                </c:pt>
                <c:pt idx="61">
                  <c:v>0.54409746628321298</c:v>
                </c:pt>
                <c:pt idx="62">
                  <c:v>0.54215038652010705</c:v>
                </c:pt>
                <c:pt idx="63">
                  <c:v>0.53315076611980505</c:v>
                </c:pt>
                <c:pt idx="64">
                  <c:v>0.52641587994300498</c:v>
                </c:pt>
                <c:pt idx="65">
                  <c:v>0.52610484643086397</c:v>
                </c:pt>
                <c:pt idx="66">
                  <c:v>0.52162801321344299</c:v>
                </c:pt>
                <c:pt idx="67">
                  <c:v>0.51796416328143802</c:v>
                </c:pt>
                <c:pt idx="68">
                  <c:v>0.51656908588557904</c:v>
                </c:pt>
                <c:pt idx="69">
                  <c:v>0.51600605508164499</c:v>
                </c:pt>
                <c:pt idx="70">
                  <c:v>0.51578992181402095</c:v>
                </c:pt>
                <c:pt idx="71">
                  <c:v>0.51318624131535695</c:v>
                </c:pt>
                <c:pt idx="72">
                  <c:v>0.513082235810295</c:v>
                </c:pt>
                <c:pt idx="73">
                  <c:v>0.50491662497489198</c:v>
                </c:pt>
                <c:pt idx="74">
                  <c:v>0.50258522901392799</c:v>
                </c:pt>
                <c:pt idx="75">
                  <c:v>0.50184612954000296</c:v>
                </c:pt>
                <c:pt idx="76">
                  <c:v>0.50071425328762398</c:v>
                </c:pt>
                <c:pt idx="77">
                  <c:v>0.499357119753496</c:v>
                </c:pt>
                <c:pt idx="78">
                  <c:v>0.49643539748368298</c:v>
                </c:pt>
                <c:pt idx="79">
                  <c:v>0.49579512767430001</c:v>
                </c:pt>
                <c:pt idx="80">
                  <c:v>0.49518034188026</c:v>
                </c:pt>
                <c:pt idx="81">
                  <c:v>0.49461300588715601</c:v>
                </c:pt>
                <c:pt idx="82">
                  <c:v>0.49231386810202499</c:v>
                </c:pt>
                <c:pt idx="83">
                  <c:v>0.48969289373416802</c:v>
                </c:pt>
                <c:pt idx="84">
                  <c:v>0.48717716761275898</c:v>
                </c:pt>
                <c:pt idx="85">
                  <c:v>0.48100524448172</c:v>
                </c:pt>
                <c:pt idx="86">
                  <c:v>0.47398483845482697</c:v>
                </c:pt>
                <c:pt idx="87">
                  <c:v>0.47305331215525598</c:v>
                </c:pt>
                <c:pt idx="88">
                  <c:v>0.46862765189450201</c:v>
                </c:pt>
                <c:pt idx="89">
                  <c:v>0.46657133087241498</c:v>
                </c:pt>
                <c:pt idx="90">
                  <c:v>0.45913971199933901</c:v>
                </c:pt>
                <c:pt idx="91">
                  <c:v>0.45859303328428702</c:v>
                </c:pt>
                <c:pt idx="92">
                  <c:v>0.456092177334256</c:v>
                </c:pt>
                <c:pt idx="93">
                  <c:v>0.45514202207457799</c:v>
                </c:pt>
                <c:pt idx="94">
                  <c:v>0.45434381384372502</c:v>
                </c:pt>
                <c:pt idx="95">
                  <c:v>0.45198911552899601</c:v>
                </c:pt>
                <c:pt idx="96">
                  <c:v>0.45130471982960302</c:v>
                </c:pt>
                <c:pt idx="97">
                  <c:v>0.44884573627357099</c:v>
                </c:pt>
                <c:pt idx="98">
                  <c:v>0.44481443759697897</c:v>
                </c:pt>
                <c:pt idx="99">
                  <c:v>0.44449567515850502</c:v>
                </c:pt>
                <c:pt idx="100">
                  <c:v>0.44333085486453599</c:v>
                </c:pt>
                <c:pt idx="101">
                  <c:v>0.43693453074021998</c:v>
                </c:pt>
                <c:pt idx="102">
                  <c:v>0.43174922394788301</c:v>
                </c:pt>
                <c:pt idx="103">
                  <c:v>0.42919705157759602</c:v>
                </c:pt>
                <c:pt idx="104">
                  <c:v>0.42914407476163802</c:v>
                </c:pt>
                <c:pt idx="105">
                  <c:v>0.42776332055593602</c:v>
                </c:pt>
                <c:pt idx="106">
                  <c:v>0.424720427868988</c:v>
                </c:pt>
                <c:pt idx="107">
                  <c:v>0.42375335068069098</c:v>
                </c:pt>
                <c:pt idx="108">
                  <c:v>0.41966533849227999</c:v>
                </c:pt>
                <c:pt idx="109">
                  <c:v>0.41865703181534503</c:v>
                </c:pt>
                <c:pt idx="110">
                  <c:v>0.41596070993297402</c:v>
                </c:pt>
                <c:pt idx="111">
                  <c:v>0.41562754115349398</c:v>
                </c:pt>
                <c:pt idx="112">
                  <c:v>0.41535585716971402</c:v>
                </c:pt>
                <c:pt idx="113">
                  <c:v>0.41264457712210101</c:v>
                </c:pt>
                <c:pt idx="114">
                  <c:v>0.40970858976336499</c:v>
                </c:pt>
                <c:pt idx="115">
                  <c:v>0.40890406447285499</c:v>
                </c:pt>
                <c:pt idx="116">
                  <c:v>0.40517845992753398</c:v>
                </c:pt>
                <c:pt idx="117">
                  <c:v>0.40260917449587902</c:v>
                </c:pt>
                <c:pt idx="118">
                  <c:v>0.40163123335411699</c:v>
                </c:pt>
                <c:pt idx="119">
                  <c:v>0.39985482206755202</c:v>
                </c:pt>
                <c:pt idx="120">
                  <c:v>0.39801778486800998</c:v>
                </c:pt>
                <c:pt idx="121">
                  <c:v>0.39701128849610401</c:v>
                </c:pt>
                <c:pt idx="122">
                  <c:v>0.39472202396227002</c:v>
                </c:pt>
                <c:pt idx="123">
                  <c:v>0.39193030421175001</c:v>
                </c:pt>
                <c:pt idx="124">
                  <c:v>0.38139500406810201</c:v>
                </c:pt>
                <c:pt idx="125">
                  <c:v>0.37911599379766198</c:v>
                </c:pt>
                <c:pt idx="126">
                  <c:v>0.37650500609856402</c:v>
                </c:pt>
                <c:pt idx="127">
                  <c:v>0.36577380820087801</c:v>
                </c:pt>
                <c:pt idx="128">
                  <c:v>0.36186032894061698</c:v>
                </c:pt>
                <c:pt idx="129">
                  <c:v>0.36155244590715402</c:v>
                </c:pt>
                <c:pt idx="130">
                  <c:v>0.35471536637369799</c:v>
                </c:pt>
                <c:pt idx="131">
                  <c:v>0.34964298440786301</c:v>
                </c:pt>
                <c:pt idx="132">
                  <c:v>0.34779759893635698</c:v>
                </c:pt>
                <c:pt idx="133">
                  <c:v>0.34570011332017703</c:v>
                </c:pt>
                <c:pt idx="134">
                  <c:v>0.34368935419806301</c:v>
                </c:pt>
                <c:pt idx="135">
                  <c:v>0.34364603999772902</c:v>
                </c:pt>
                <c:pt idx="136">
                  <c:v>0.34208905440631299</c:v>
                </c:pt>
                <c:pt idx="137">
                  <c:v>0.34182893593403901</c:v>
                </c:pt>
                <c:pt idx="138">
                  <c:v>0.33297358256482101</c:v>
                </c:pt>
                <c:pt idx="139">
                  <c:v>0.33143130520303499</c:v>
                </c:pt>
                <c:pt idx="140">
                  <c:v>0.32884758662743802</c:v>
                </c:pt>
                <c:pt idx="141">
                  <c:v>0.32690430644506102</c:v>
                </c:pt>
                <c:pt idx="142">
                  <c:v>0.32480329073036301</c:v>
                </c:pt>
                <c:pt idx="143">
                  <c:v>0.32059954630332399</c:v>
                </c:pt>
                <c:pt idx="144">
                  <c:v>0.31900721842266899</c:v>
                </c:pt>
                <c:pt idx="145">
                  <c:v>0.31652263352910198</c:v>
                </c:pt>
                <c:pt idx="146">
                  <c:v>0.30914491390674698</c:v>
                </c:pt>
                <c:pt idx="147">
                  <c:v>0.30014608274670701</c:v>
                </c:pt>
                <c:pt idx="148">
                  <c:v>0.29814419196210801</c:v>
                </c:pt>
                <c:pt idx="149">
                  <c:v>0.295424877466891</c:v>
                </c:pt>
                <c:pt idx="150">
                  <c:v>0.28723883416267398</c:v>
                </c:pt>
                <c:pt idx="151">
                  <c:v>0.28345311671176598</c:v>
                </c:pt>
                <c:pt idx="152">
                  <c:v>0.28006747896083201</c:v>
                </c:pt>
                <c:pt idx="153">
                  <c:v>0.27767547120833003</c:v>
                </c:pt>
                <c:pt idx="154">
                  <c:v>0.27323052807509401</c:v>
                </c:pt>
                <c:pt idx="155">
                  <c:v>0.26898911851499702</c:v>
                </c:pt>
                <c:pt idx="156">
                  <c:v>0.26694524486562099</c:v>
                </c:pt>
                <c:pt idx="157">
                  <c:v>0.26176785001390701</c:v>
                </c:pt>
                <c:pt idx="158">
                  <c:v>0.25877450987858702</c:v>
                </c:pt>
                <c:pt idx="159">
                  <c:v>0.25650517512530102</c:v>
                </c:pt>
                <c:pt idx="160">
                  <c:v>0.25596847718055399</c:v>
                </c:pt>
                <c:pt idx="161">
                  <c:v>0.249617282436082</c:v>
                </c:pt>
                <c:pt idx="162">
                  <c:v>0.246048628587309</c:v>
                </c:pt>
                <c:pt idx="163">
                  <c:v>0.24469282411930299</c:v>
                </c:pt>
                <c:pt idx="164">
                  <c:v>0.24137316827666799</c:v>
                </c:pt>
                <c:pt idx="165">
                  <c:v>0.24095554613352199</c:v>
                </c:pt>
                <c:pt idx="166">
                  <c:v>0.23852678626609899</c:v>
                </c:pt>
                <c:pt idx="167">
                  <c:v>0.231816504689388</c:v>
                </c:pt>
                <c:pt idx="168">
                  <c:v>0.23047600694719</c:v>
                </c:pt>
                <c:pt idx="169">
                  <c:v>0.226249271794077</c:v>
                </c:pt>
                <c:pt idx="170">
                  <c:v>0.22553154371431</c:v>
                </c:pt>
                <c:pt idx="171">
                  <c:v>0.22227522138490499</c:v>
                </c:pt>
                <c:pt idx="172">
                  <c:v>0.21499122864866299</c:v>
                </c:pt>
                <c:pt idx="173">
                  <c:v>0.203485730416435</c:v>
                </c:pt>
                <c:pt idx="174">
                  <c:v>0.199039651472046</c:v>
                </c:pt>
                <c:pt idx="175">
                  <c:v>0.17973788636760199</c:v>
                </c:pt>
                <c:pt idx="176">
                  <c:v>0.176193771701457</c:v>
                </c:pt>
                <c:pt idx="177">
                  <c:v>0.17412694473652399</c:v>
                </c:pt>
                <c:pt idx="178">
                  <c:v>0.16742065209622101</c:v>
                </c:pt>
                <c:pt idx="179">
                  <c:v>0.16435360438697</c:v>
                </c:pt>
                <c:pt idx="180">
                  <c:v>0.15726389956314701</c:v>
                </c:pt>
                <c:pt idx="181">
                  <c:v>0.130517558274513</c:v>
                </c:pt>
                <c:pt idx="182">
                  <c:v>0.12918965595925999</c:v>
                </c:pt>
                <c:pt idx="183">
                  <c:v>0.123904900889084</c:v>
                </c:pt>
                <c:pt idx="184">
                  <c:v>0.11912991302874</c:v>
                </c:pt>
                <c:pt idx="185">
                  <c:v>0.10622102859603701</c:v>
                </c:pt>
                <c:pt idx="186">
                  <c:v>0.10478786671573</c:v>
                </c:pt>
                <c:pt idx="187">
                  <c:v>9.7531203887841506E-2</c:v>
                </c:pt>
                <c:pt idx="188">
                  <c:v>9.6082368266277807E-2</c:v>
                </c:pt>
                <c:pt idx="189">
                  <c:v>8.5428058104748197E-2</c:v>
                </c:pt>
                <c:pt idx="190">
                  <c:v>8.2817580997836704E-2</c:v>
                </c:pt>
                <c:pt idx="191">
                  <c:v>8.14326181782212E-2</c:v>
                </c:pt>
                <c:pt idx="192">
                  <c:v>6.8383188921597393E-2</c:v>
                </c:pt>
                <c:pt idx="193">
                  <c:v>6.21915741998448E-2</c:v>
                </c:pt>
                <c:pt idx="194">
                  <c:v>2.47756536035031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4789800"/>
        <c:axId val="334790192"/>
      </c:scatterChart>
      <c:valAx>
        <c:axId val="334789800"/>
        <c:scaling>
          <c:orientation val="minMax"/>
          <c:max val="1"/>
          <c:min val="0.30000000000000004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Module membership in Blu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90192"/>
        <c:crosses val="autoZero"/>
        <c:crossBetween val="midCat"/>
      </c:valAx>
      <c:valAx>
        <c:axId val="3347901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Gene significance for malate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89800"/>
        <c:crossesAt val="0"/>
        <c:crossBetween val="midCat"/>
      </c:valAx>
      <c:spPr>
        <a:solidFill>
          <a:schemeClr val="bg1">
            <a:lumMod val="50000"/>
          </a:schemeClr>
        </a:solidFill>
        <a:ln w="3175"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 w="3175"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geneInfo-1301Power6Cut025-2-cop'!$AE$1</c:f>
              <c:strCache>
                <c:ptCount val="1"/>
                <c:pt idx="0">
                  <c:v>ABS-MM.yellow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rgbClr val="FFFF00"/>
                </a:solidFill>
              </a:ln>
            </c:spPr>
          </c:marker>
          <c:xVal>
            <c:numRef>
              <c:f>'geneInfo-1301Power6Cut025-2-cop'!$AE$1169:$AE$1302</c:f>
              <c:numCache>
                <c:formatCode>General</c:formatCode>
                <c:ptCount val="134"/>
                <c:pt idx="0">
                  <c:v>0.62935507702958804</c:v>
                </c:pt>
                <c:pt idx="1">
                  <c:v>0.79057261817309299</c:v>
                </c:pt>
                <c:pt idx="2">
                  <c:v>0.72919897902752695</c:v>
                </c:pt>
                <c:pt idx="3">
                  <c:v>0.71853257280788096</c:v>
                </c:pt>
                <c:pt idx="4">
                  <c:v>0.59595012834971195</c:v>
                </c:pt>
                <c:pt idx="5">
                  <c:v>0.70911188402303604</c:v>
                </c:pt>
                <c:pt idx="6">
                  <c:v>0.72722390632276301</c:v>
                </c:pt>
                <c:pt idx="7">
                  <c:v>0.83255736253477897</c:v>
                </c:pt>
                <c:pt idx="8">
                  <c:v>0.71259922873391401</c:v>
                </c:pt>
                <c:pt idx="9">
                  <c:v>0.775576097624607</c:v>
                </c:pt>
                <c:pt idx="10">
                  <c:v>0.80269764827554302</c:v>
                </c:pt>
                <c:pt idx="11">
                  <c:v>0.87355255751016003</c:v>
                </c:pt>
                <c:pt idx="12">
                  <c:v>0.73547236330024701</c:v>
                </c:pt>
                <c:pt idx="13">
                  <c:v>0.85568237817892701</c:v>
                </c:pt>
                <c:pt idx="14">
                  <c:v>0.79991714623587995</c:v>
                </c:pt>
                <c:pt idx="15">
                  <c:v>0.84752806965924998</c:v>
                </c:pt>
                <c:pt idx="16">
                  <c:v>0.55142840689323802</c:v>
                </c:pt>
                <c:pt idx="17">
                  <c:v>0.838638691690197</c:v>
                </c:pt>
                <c:pt idx="18">
                  <c:v>0.781584943163525</c:v>
                </c:pt>
                <c:pt idx="19">
                  <c:v>0.89765703519253504</c:v>
                </c:pt>
                <c:pt idx="20">
                  <c:v>0.78141050170875903</c:v>
                </c:pt>
                <c:pt idx="21">
                  <c:v>0.85381355664514602</c:v>
                </c:pt>
                <c:pt idx="22">
                  <c:v>0.93718734956614802</c:v>
                </c:pt>
                <c:pt idx="23">
                  <c:v>0.82699502700911498</c:v>
                </c:pt>
                <c:pt idx="24">
                  <c:v>0.72576667206457002</c:v>
                </c:pt>
                <c:pt idx="25">
                  <c:v>0.73231188579639706</c:v>
                </c:pt>
                <c:pt idx="26">
                  <c:v>0.82915144377171901</c:v>
                </c:pt>
                <c:pt idx="27">
                  <c:v>0.93093428003898404</c:v>
                </c:pt>
                <c:pt idx="28">
                  <c:v>0.66820505300500799</c:v>
                </c:pt>
                <c:pt idx="29">
                  <c:v>0.85687864920853296</c:v>
                </c:pt>
                <c:pt idx="30">
                  <c:v>0.59131644157933205</c:v>
                </c:pt>
                <c:pt idx="31">
                  <c:v>0.84689935973253905</c:v>
                </c:pt>
                <c:pt idx="32">
                  <c:v>0.85968005250448098</c:v>
                </c:pt>
                <c:pt idx="33">
                  <c:v>0.79221989205240295</c:v>
                </c:pt>
                <c:pt idx="34">
                  <c:v>0.72236169915023696</c:v>
                </c:pt>
                <c:pt idx="35">
                  <c:v>0.71209188011732805</c:v>
                </c:pt>
                <c:pt idx="36">
                  <c:v>0.81558127176611295</c:v>
                </c:pt>
                <c:pt idx="37">
                  <c:v>0.62214942644512805</c:v>
                </c:pt>
                <c:pt idx="38">
                  <c:v>0.66743706865249497</c:v>
                </c:pt>
                <c:pt idx="39">
                  <c:v>0.94722294408687702</c:v>
                </c:pt>
                <c:pt idx="40">
                  <c:v>0.81008273485831805</c:v>
                </c:pt>
                <c:pt idx="41">
                  <c:v>0.72272705432798701</c:v>
                </c:pt>
                <c:pt idx="42">
                  <c:v>0.89350026495143298</c:v>
                </c:pt>
                <c:pt idx="43">
                  <c:v>0.72408084680632401</c:v>
                </c:pt>
                <c:pt idx="44">
                  <c:v>0.82807007674955002</c:v>
                </c:pt>
                <c:pt idx="45">
                  <c:v>0.797447110735093</c:v>
                </c:pt>
                <c:pt idx="46">
                  <c:v>0.82894493624778598</c:v>
                </c:pt>
                <c:pt idx="47">
                  <c:v>0.71558758652309695</c:v>
                </c:pt>
                <c:pt idx="48">
                  <c:v>0.89499601579647903</c:v>
                </c:pt>
                <c:pt idx="49">
                  <c:v>0.82539108489853696</c:v>
                </c:pt>
                <c:pt idx="50">
                  <c:v>0.91663454719931603</c:v>
                </c:pt>
                <c:pt idx="51">
                  <c:v>0.70866303284604304</c:v>
                </c:pt>
                <c:pt idx="52">
                  <c:v>0.84784293486243001</c:v>
                </c:pt>
                <c:pt idx="53">
                  <c:v>0.74474850108871904</c:v>
                </c:pt>
                <c:pt idx="54">
                  <c:v>0.75200101275323805</c:v>
                </c:pt>
                <c:pt idx="55">
                  <c:v>0.64197671778228205</c:v>
                </c:pt>
                <c:pt idx="56">
                  <c:v>0.59197712000681801</c:v>
                </c:pt>
                <c:pt idx="57">
                  <c:v>0.76346838481723101</c:v>
                </c:pt>
                <c:pt idx="58">
                  <c:v>0.76970242458171501</c:v>
                </c:pt>
                <c:pt idx="59">
                  <c:v>0.78737066949786405</c:v>
                </c:pt>
                <c:pt idx="60">
                  <c:v>0.819671543243087</c:v>
                </c:pt>
                <c:pt idx="61">
                  <c:v>0.57059437099946697</c:v>
                </c:pt>
                <c:pt idx="62">
                  <c:v>0.82190410365566702</c:v>
                </c:pt>
                <c:pt idx="63">
                  <c:v>0.60768963783684504</c:v>
                </c:pt>
                <c:pt idx="64">
                  <c:v>0.78890149860436698</c:v>
                </c:pt>
                <c:pt idx="65">
                  <c:v>0.87935431287613197</c:v>
                </c:pt>
                <c:pt idx="66">
                  <c:v>0.86939727422669999</c:v>
                </c:pt>
                <c:pt idx="67">
                  <c:v>0.87788568827886904</c:v>
                </c:pt>
                <c:pt idx="68">
                  <c:v>0.86958943188558102</c:v>
                </c:pt>
                <c:pt idx="69">
                  <c:v>0.81028167747563495</c:v>
                </c:pt>
                <c:pt idx="70">
                  <c:v>0.92944492862794204</c:v>
                </c:pt>
                <c:pt idx="71">
                  <c:v>0.86213893322720603</c:v>
                </c:pt>
                <c:pt idx="72">
                  <c:v>0.81517710804966004</c:v>
                </c:pt>
                <c:pt idx="73">
                  <c:v>0.66945323827954595</c:v>
                </c:pt>
                <c:pt idx="74">
                  <c:v>0.88369139810155695</c:v>
                </c:pt>
                <c:pt idx="75">
                  <c:v>0.698169058291228</c:v>
                </c:pt>
                <c:pt idx="76">
                  <c:v>0.84521432283066</c:v>
                </c:pt>
                <c:pt idx="77">
                  <c:v>0.84985926799670097</c:v>
                </c:pt>
                <c:pt idx="78">
                  <c:v>0.72857453648584103</c:v>
                </c:pt>
                <c:pt idx="79">
                  <c:v>0.77183303872545905</c:v>
                </c:pt>
                <c:pt idx="80">
                  <c:v>0.87938319429873502</c:v>
                </c:pt>
                <c:pt idx="81">
                  <c:v>0.93508040000914205</c:v>
                </c:pt>
                <c:pt idx="82">
                  <c:v>0.788840161394739</c:v>
                </c:pt>
                <c:pt idx="83">
                  <c:v>0.72909432948017106</c:v>
                </c:pt>
                <c:pt idx="84">
                  <c:v>0.57858324387043403</c:v>
                </c:pt>
                <c:pt idx="85">
                  <c:v>0.79560315601818399</c:v>
                </c:pt>
                <c:pt idx="86">
                  <c:v>0.67711322880973901</c:v>
                </c:pt>
                <c:pt idx="87">
                  <c:v>0.54735394674325399</c:v>
                </c:pt>
                <c:pt idx="88">
                  <c:v>0.91666223631149102</c:v>
                </c:pt>
                <c:pt idx="89">
                  <c:v>0.87095864160081105</c:v>
                </c:pt>
                <c:pt idx="90">
                  <c:v>0.69148113000887002</c:v>
                </c:pt>
                <c:pt idx="91">
                  <c:v>0.84072876499777305</c:v>
                </c:pt>
                <c:pt idx="92">
                  <c:v>0.75342086451899903</c:v>
                </c:pt>
                <c:pt idx="93">
                  <c:v>0.79014520834426205</c:v>
                </c:pt>
                <c:pt idx="94">
                  <c:v>0.90663537935569305</c:v>
                </c:pt>
                <c:pt idx="95">
                  <c:v>0.87395513105492195</c:v>
                </c:pt>
                <c:pt idx="96">
                  <c:v>0.69194433270544797</c:v>
                </c:pt>
                <c:pt idx="97">
                  <c:v>0.83350971750041503</c:v>
                </c:pt>
                <c:pt idx="98">
                  <c:v>0.60781520727416305</c:v>
                </c:pt>
                <c:pt idx="99">
                  <c:v>0.60845820695879405</c:v>
                </c:pt>
                <c:pt idx="100">
                  <c:v>0.78923631686228701</c:v>
                </c:pt>
                <c:pt idx="101">
                  <c:v>0.78828857112796602</c:v>
                </c:pt>
                <c:pt idx="102">
                  <c:v>0.89697479394109603</c:v>
                </c:pt>
                <c:pt idx="103">
                  <c:v>0.75283221415962198</c:v>
                </c:pt>
                <c:pt idx="104">
                  <c:v>0.70925789451358001</c:v>
                </c:pt>
                <c:pt idx="105">
                  <c:v>0.79860978027214402</c:v>
                </c:pt>
                <c:pt idx="106">
                  <c:v>0.86596839259719105</c:v>
                </c:pt>
                <c:pt idx="107">
                  <c:v>0.84307415163339405</c:v>
                </c:pt>
                <c:pt idx="108">
                  <c:v>0.77464069882279196</c:v>
                </c:pt>
                <c:pt idx="109">
                  <c:v>0.81072491035102601</c:v>
                </c:pt>
                <c:pt idx="110">
                  <c:v>0.62158407260402704</c:v>
                </c:pt>
                <c:pt idx="111">
                  <c:v>0.61702332303487695</c:v>
                </c:pt>
                <c:pt idx="112">
                  <c:v>0.88196878569153903</c:v>
                </c:pt>
                <c:pt idx="113">
                  <c:v>0.77346879886297604</c:v>
                </c:pt>
                <c:pt idx="114">
                  <c:v>0.73930826624191603</c:v>
                </c:pt>
                <c:pt idx="115">
                  <c:v>0.70148073875056405</c:v>
                </c:pt>
                <c:pt idx="116">
                  <c:v>0.81705616990308105</c:v>
                </c:pt>
                <c:pt idx="117">
                  <c:v>0.54123749749450201</c:v>
                </c:pt>
                <c:pt idx="118">
                  <c:v>0.75286645073319103</c:v>
                </c:pt>
                <c:pt idx="119">
                  <c:v>0.82589411155918502</c:v>
                </c:pt>
                <c:pt idx="120">
                  <c:v>0.88298291295346798</c:v>
                </c:pt>
                <c:pt idx="121">
                  <c:v>0.635408022224217</c:v>
                </c:pt>
                <c:pt idx="122">
                  <c:v>0.78254095180430205</c:v>
                </c:pt>
                <c:pt idx="123">
                  <c:v>0.77101577337709903</c:v>
                </c:pt>
                <c:pt idx="124">
                  <c:v>0.76726559622493595</c:v>
                </c:pt>
                <c:pt idx="125">
                  <c:v>0.77676770608307599</c:v>
                </c:pt>
                <c:pt idx="126">
                  <c:v>0.74805521704630296</c:v>
                </c:pt>
                <c:pt idx="127">
                  <c:v>0.69956322797338</c:v>
                </c:pt>
                <c:pt idx="128">
                  <c:v>0.54577539291702903</c:v>
                </c:pt>
                <c:pt idx="129">
                  <c:v>0.62190966821624905</c:v>
                </c:pt>
                <c:pt idx="130">
                  <c:v>0.75825898662769298</c:v>
                </c:pt>
                <c:pt idx="131">
                  <c:v>0.61580632241566802</c:v>
                </c:pt>
                <c:pt idx="132">
                  <c:v>0.46422728601992502</c:v>
                </c:pt>
                <c:pt idx="133">
                  <c:v>0.55381868568578596</c:v>
                </c:pt>
              </c:numCache>
            </c:numRef>
          </c:xVal>
          <c:yVal>
            <c:numRef>
              <c:f>'geneInfo-1301Power6Cut025-2-cop'!$F$1169:$F$1302</c:f>
              <c:numCache>
                <c:formatCode>General</c:formatCode>
                <c:ptCount val="134"/>
                <c:pt idx="0">
                  <c:v>0.78191283865851002</c:v>
                </c:pt>
                <c:pt idx="1">
                  <c:v>0.77875509322682401</c:v>
                </c:pt>
                <c:pt idx="2">
                  <c:v>0.77320379095832803</c:v>
                </c:pt>
                <c:pt idx="3">
                  <c:v>0.75729121392449505</c:v>
                </c:pt>
                <c:pt idx="4">
                  <c:v>0.73116128347314802</c:v>
                </c:pt>
                <c:pt idx="5">
                  <c:v>0.729964839939094</c:v>
                </c:pt>
                <c:pt idx="6">
                  <c:v>0.72924278033323298</c:v>
                </c:pt>
                <c:pt idx="7">
                  <c:v>0.72887133570155305</c:v>
                </c:pt>
                <c:pt idx="8">
                  <c:v>0.71660325397691105</c:v>
                </c:pt>
                <c:pt idx="9">
                  <c:v>0.70856586979704494</c:v>
                </c:pt>
                <c:pt idx="10">
                  <c:v>0.69677313007159003</c:v>
                </c:pt>
                <c:pt idx="11">
                  <c:v>0.69020515286064299</c:v>
                </c:pt>
                <c:pt idx="12">
                  <c:v>0.68736291912502501</c:v>
                </c:pt>
                <c:pt idx="13">
                  <c:v>0.67956549462828897</c:v>
                </c:pt>
                <c:pt idx="14">
                  <c:v>0.67682596512228599</c:v>
                </c:pt>
                <c:pt idx="15">
                  <c:v>0.67233238013138596</c:v>
                </c:pt>
                <c:pt idx="16">
                  <c:v>0.66091201064205096</c:v>
                </c:pt>
                <c:pt idx="17">
                  <c:v>0.65908299632104705</c:v>
                </c:pt>
                <c:pt idx="18">
                  <c:v>0.657362064878107</c:v>
                </c:pt>
                <c:pt idx="19">
                  <c:v>0.65379167392778703</c:v>
                </c:pt>
                <c:pt idx="20">
                  <c:v>0.65202406040212202</c:v>
                </c:pt>
                <c:pt idx="21">
                  <c:v>0.65200921636647402</c:v>
                </c:pt>
                <c:pt idx="22">
                  <c:v>0.65128955131117405</c:v>
                </c:pt>
                <c:pt idx="23">
                  <c:v>0.64486735865589695</c:v>
                </c:pt>
                <c:pt idx="24">
                  <c:v>0.64414858733869296</c:v>
                </c:pt>
                <c:pt idx="25">
                  <c:v>0.64376747914548305</c:v>
                </c:pt>
                <c:pt idx="26">
                  <c:v>0.643019751901314</c:v>
                </c:pt>
                <c:pt idx="27">
                  <c:v>0.63811844458618905</c:v>
                </c:pt>
                <c:pt idx="28">
                  <c:v>0.63442083263250104</c:v>
                </c:pt>
                <c:pt idx="29">
                  <c:v>0.63315195175732897</c:v>
                </c:pt>
                <c:pt idx="30">
                  <c:v>0.63251042342003505</c:v>
                </c:pt>
                <c:pt idx="31">
                  <c:v>0.62948779575497604</c:v>
                </c:pt>
                <c:pt idx="32">
                  <c:v>0.62834726240928296</c:v>
                </c:pt>
                <c:pt idx="33">
                  <c:v>0.62730529032507398</c:v>
                </c:pt>
                <c:pt idx="34">
                  <c:v>0.623879578122431</c:v>
                </c:pt>
                <c:pt idx="35">
                  <c:v>0.61660526048013198</c:v>
                </c:pt>
                <c:pt idx="36">
                  <c:v>0.61064716456279</c:v>
                </c:pt>
                <c:pt idx="37">
                  <c:v>0.60907302092540205</c:v>
                </c:pt>
                <c:pt idx="38">
                  <c:v>0.60877887912334605</c:v>
                </c:pt>
                <c:pt idx="39">
                  <c:v>0.60445909036593004</c:v>
                </c:pt>
                <c:pt idx="40">
                  <c:v>0.60206092334091699</c:v>
                </c:pt>
                <c:pt idx="41">
                  <c:v>0.59959191227766495</c:v>
                </c:pt>
                <c:pt idx="42">
                  <c:v>0.589458340880886</c:v>
                </c:pt>
                <c:pt idx="43">
                  <c:v>0.58390347560328204</c:v>
                </c:pt>
                <c:pt idx="44">
                  <c:v>0.58153643536239197</c:v>
                </c:pt>
                <c:pt idx="45">
                  <c:v>0.58137931218641503</c:v>
                </c:pt>
                <c:pt idx="46">
                  <c:v>0.57985332335744899</c:v>
                </c:pt>
                <c:pt idx="47">
                  <c:v>0.57878803856708905</c:v>
                </c:pt>
                <c:pt idx="48">
                  <c:v>0.57061214131311699</c:v>
                </c:pt>
                <c:pt idx="49">
                  <c:v>0.569144349635059</c:v>
                </c:pt>
                <c:pt idx="50">
                  <c:v>0.56340622951839803</c:v>
                </c:pt>
                <c:pt idx="51">
                  <c:v>0.56274504144887405</c:v>
                </c:pt>
                <c:pt idx="52">
                  <c:v>0.56134344170693895</c:v>
                </c:pt>
                <c:pt idx="53">
                  <c:v>0.56011596220959403</c:v>
                </c:pt>
                <c:pt idx="54">
                  <c:v>0.55332919487215104</c:v>
                </c:pt>
                <c:pt idx="55">
                  <c:v>0.55313876514414995</c:v>
                </c:pt>
                <c:pt idx="56">
                  <c:v>0.55293381511824202</c:v>
                </c:pt>
                <c:pt idx="57">
                  <c:v>0.55243535518268905</c:v>
                </c:pt>
                <c:pt idx="58">
                  <c:v>0.54818459595010705</c:v>
                </c:pt>
                <c:pt idx="59">
                  <c:v>0.54805868743214003</c:v>
                </c:pt>
                <c:pt idx="60">
                  <c:v>0.54786741807542505</c:v>
                </c:pt>
                <c:pt idx="61">
                  <c:v>0.54775965813760497</c:v>
                </c:pt>
                <c:pt idx="62">
                  <c:v>0.54769300525654496</c:v>
                </c:pt>
                <c:pt idx="63">
                  <c:v>0.54578449983017996</c:v>
                </c:pt>
                <c:pt idx="64">
                  <c:v>0.54545241609207595</c:v>
                </c:pt>
                <c:pt idx="65">
                  <c:v>0.54511363977534799</c:v>
                </c:pt>
                <c:pt idx="66">
                  <c:v>0.54401545087089498</c:v>
                </c:pt>
                <c:pt idx="67">
                  <c:v>0.54337288559079</c:v>
                </c:pt>
                <c:pt idx="68">
                  <c:v>0.54020143868932102</c:v>
                </c:pt>
                <c:pt idx="69">
                  <c:v>0.53969701017537297</c:v>
                </c:pt>
                <c:pt idx="70">
                  <c:v>0.53961122136717998</c:v>
                </c:pt>
                <c:pt idx="71">
                  <c:v>0.53663234102912605</c:v>
                </c:pt>
                <c:pt idx="72">
                  <c:v>0.53517251829334</c:v>
                </c:pt>
                <c:pt idx="73">
                  <c:v>0.53288276429380399</c:v>
                </c:pt>
                <c:pt idx="74">
                  <c:v>0.52459814459482601</c:v>
                </c:pt>
                <c:pt idx="75">
                  <c:v>0.51557086542574404</c:v>
                </c:pt>
                <c:pt idx="76">
                  <c:v>0.51100324669850705</c:v>
                </c:pt>
                <c:pt idx="77">
                  <c:v>0.50796637970363301</c:v>
                </c:pt>
                <c:pt idx="78">
                  <c:v>0.507416036728356</c:v>
                </c:pt>
                <c:pt idx="79">
                  <c:v>0.50534868921430698</c:v>
                </c:pt>
                <c:pt idx="80">
                  <c:v>0.50352953778952003</c:v>
                </c:pt>
                <c:pt idx="81">
                  <c:v>0.49272390012258799</c:v>
                </c:pt>
                <c:pt idx="82">
                  <c:v>0.49220207631584501</c:v>
                </c:pt>
                <c:pt idx="83">
                  <c:v>0.48978747076999002</c:v>
                </c:pt>
                <c:pt idx="84">
                  <c:v>0.48723981404153999</c:v>
                </c:pt>
                <c:pt idx="85">
                  <c:v>0.486047497415528</c:v>
                </c:pt>
                <c:pt idx="86">
                  <c:v>0.48499778966144402</c:v>
                </c:pt>
                <c:pt idx="87">
                  <c:v>0.48156364119384398</c:v>
                </c:pt>
                <c:pt idx="88">
                  <c:v>0.48101403641860002</c:v>
                </c:pt>
                <c:pt idx="89">
                  <c:v>0.477435657205388</c:v>
                </c:pt>
                <c:pt idx="90">
                  <c:v>0.46577226952294798</c:v>
                </c:pt>
                <c:pt idx="91">
                  <c:v>0.46287716719980398</c:v>
                </c:pt>
                <c:pt idx="92">
                  <c:v>0.45858556660320399</c:v>
                </c:pt>
                <c:pt idx="93">
                  <c:v>0.45782084655922101</c:v>
                </c:pt>
                <c:pt idx="94">
                  <c:v>0.45358133759666702</c:v>
                </c:pt>
                <c:pt idx="95">
                  <c:v>0.45325652240200698</c:v>
                </c:pt>
                <c:pt idx="96">
                  <c:v>0.44285750589463302</c:v>
                </c:pt>
                <c:pt idx="97">
                  <c:v>0.44231719961731703</c:v>
                </c:pt>
                <c:pt idx="98">
                  <c:v>0.44146748410610498</c:v>
                </c:pt>
                <c:pt idx="99">
                  <c:v>0.44078631398509899</c:v>
                </c:pt>
                <c:pt idx="100">
                  <c:v>0.43617886382092302</c:v>
                </c:pt>
                <c:pt idx="101">
                  <c:v>0.43490441128815399</c:v>
                </c:pt>
                <c:pt idx="102">
                  <c:v>0.43077734972362502</c:v>
                </c:pt>
                <c:pt idx="103">
                  <c:v>0.42872059172453197</c:v>
                </c:pt>
                <c:pt idx="104">
                  <c:v>0.427606112685606</c:v>
                </c:pt>
                <c:pt idx="105">
                  <c:v>0.42082093773403101</c:v>
                </c:pt>
                <c:pt idx="106">
                  <c:v>0.41968097648195601</c:v>
                </c:pt>
                <c:pt idx="107">
                  <c:v>0.41902671408150599</c:v>
                </c:pt>
                <c:pt idx="108">
                  <c:v>0.41823024473909698</c:v>
                </c:pt>
                <c:pt idx="109">
                  <c:v>0.41037668496694901</c:v>
                </c:pt>
                <c:pt idx="110">
                  <c:v>0.40934238605090001</c:v>
                </c:pt>
                <c:pt idx="111">
                  <c:v>0.40165412269255402</c:v>
                </c:pt>
                <c:pt idx="112">
                  <c:v>0.38528520818749701</c:v>
                </c:pt>
                <c:pt idx="113">
                  <c:v>0.37861832882344498</c:v>
                </c:pt>
                <c:pt idx="114">
                  <c:v>0.37818967671730602</c:v>
                </c:pt>
                <c:pt idx="115">
                  <c:v>0.37484233970207098</c:v>
                </c:pt>
                <c:pt idx="116">
                  <c:v>0.370553457766153</c:v>
                </c:pt>
                <c:pt idx="117">
                  <c:v>0.35885292463629198</c:v>
                </c:pt>
                <c:pt idx="118">
                  <c:v>0.34348723646266399</c:v>
                </c:pt>
                <c:pt idx="119">
                  <c:v>0.33612493703148599</c:v>
                </c:pt>
                <c:pt idx="120">
                  <c:v>0.33433415676882</c:v>
                </c:pt>
                <c:pt idx="121">
                  <c:v>0.32946048884379697</c:v>
                </c:pt>
                <c:pt idx="122">
                  <c:v>0.31974844383887002</c:v>
                </c:pt>
                <c:pt idx="123">
                  <c:v>0.31974627135625899</c:v>
                </c:pt>
                <c:pt idx="124">
                  <c:v>0.304290886574206</c:v>
                </c:pt>
                <c:pt idx="125">
                  <c:v>0.29762065766447798</c:v>
                </c:pt>
                <c:pt idx="126">
                  <c:v>0.25854627641164901</c:v>
                </c:pt>
                <c:pt idx="127">
                  <c:v>0.23019424214824399</c:v>
                </c:pt>
                <c:pt idx="128">
                  <c:v>0.22876484502288499</c:v>
                </c:pt>
                <c:pt idx="129">
                  <c:v>0.21938426047661599</c:v>
                </c:pt>
                <c:pt idx="130">
                  <c:v>0.20962703769527</c:v>
                </c:pt>
                <c:pt idx="131">
                  <c:v>0.19034969496740001</c:v>
                </c:pt>
                <c:pt idx="132">
                  <c:v>8.8650584853612394E-2</c:v>
                </c:pt>
                <c:pt idx="133">
                  <c:v>3.1812504897877202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4790976"/>
        <c:axId val="334791368"/>
      </c:scatterChart>
      <c:valAx>
        <c:axId val="334790976"/>
        <c:scaling>
          <c:orientation val="minMax"/>
          <c:max val="1"/>
          <c:min val="0.4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sz="1000" b="0" i="0" u="none" strike="noStrike" baseline="0" dirty="0" smtClean="0">
                    <a:effectLst/>
                  </a:rPr>
                  <a:t>Module membership in Yellow</a:t>
                </a:r>
                <a:endParaRPr lang="en-US" sz="1000" b="0" i="0" u="none" strike="noStrike" baseline="0" dirty="0">
                  <a:effectLst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91368"/>
        <c:crosses val="autoZero"/>
        <c:crossBetween val="midCat"/>
      </c:valAx>
      <c:valAx>
        <c:axId val="3347913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Gene significance for malat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90976"/>
        <c:crosses val="autoZero"/>
        <c:crossBetween val="midCat"/>
        <c:majorUnit val="0.1"/>
      </c:valAx>
      <c:spPr>
        <a:solidFill>
          <a:schemeClr val="bg1">
            <a:lumMod val="50000"/>
          </a:schemeClr>
        </a:solidFill>
        <a:ln w="3175"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geneInfo-1301Power6Cut025-2-cop'!$AG$1</c:f>
              <c:strCache>
                <c:ptCount val="1"/>
                <c:pt idx="0">
                  <c:v>ABS-MM.brown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rgbClr val="96210A"/>
                </a:solidFill>
              </a:ln>
            </c:spPr>
          </c:marker>
          <c:xVal>
            <c:numRef>
              <c:f>'geneInfo-1301Power6Cut025-2-cop'!$AG$294:$AG$474</c:f>
              <c:numCache>
                <c:formatCode>General</c:formatCode>
                <c:ptCount val="181"/>
                <c:pt idx="0">
                  <c:v>0.86367144231091897</c:v>
                </c:pt>
                <c:pt idx="1">
                  <c:v>0.77750132283071505</c:v>
                </c:pt>
                <c:pt idx="2">
                  <c:v>0.63240751172126897</c:v>
                </c:pt>
                <c:pt idx="3">
                  <c:v>0.53367777447230702</c:v>
                </c:pt>
                <c:pt idx="4">
                  <c:v>0.88286301886787599</c:v>
                </c:pt>
                <c:pt idx="5">
                  <c:v>0.70559452517365095</c:v>
                </c:pt>
                <c:pt idx="6">
                  <c:v>0.88746709933203105</c:v>
                </c:pt>
                <c:pt idx="7">
                  <c:v>0.90593052619189895</c:v>
                </c:pt>
                <c:pt idx="8">
                  <c:v>0.55661967893131203</c:v>
                </c:pt>
                <c:pt idx="9">
                  <c:v>0.79619999266951302</c:v>
                </c:pt>
                <c:pt idx="10">
                  <c:v>0.73243892491153395</c:v>
                </c:pt>
                <c:pt idx="11">
                  <c:v>0.84851041049293296</c:v>
                </c:pt>
                <c:pt idx="12">
                  <c:v>0.86197892327735104</c:v>
                </c:pt>
                <c:pt idx="13">
                  <c:v>0.82123633708003096</c:v>
                </c:pt>
                <c:pt idx="14">
                  <c:v>0.76385011701623395</c:v>
                </c:pt>
                <c:pt idx="15">
                  <c:v>0.80869694498111699</c:v>
                </c:pt>
                <c:pt idx="16">
                  <c:v>0.74702858677286799</c:v>
                </c:pt>
                <c:pt idx="17">
                  <c:v>0.81978483411859204</c:v>
                </c:pt>
                <c:pt idx="18">
                  <c:v>0.83494906576331995</c:v>
                </c:pt>
                <c:pt idx="19">
                  <c:v>0.90238551762931496</c:v>
                </c:pt>
                <c:pt idx="20">
                  <c:v>0.87950954417905103</c:v>
                </c:pt>
                <c:pt idx="21">
                  <c:v>0.83107426183158195</c:v>
                </c:pt>
                <c:pt idx="22">
                  <c:v>0.72319971361151303</c:v>
                </c:pt>
                <c:pt idx="23">
                  <c:v>0.92920241423087302</c:v>
                </c:pt>
                <c:pt idx="24">
                  <c:v>0.91874696908947595</c:v>
                </c:pt>
                <c:pt idx="25">
                  <c:v>0.69388998649042799</c:v>
                </c:pt>
                <c:pt idx="26">
                  <c:v>0.93168761696761304</c:v>
                </c:pt>
                <c:pt idx="27">
                  <c:v>0.73230055086773005</c:v>
                </c:pt>
                <c:pt idx="28">
                  <c:v>0.58550536324765001</c:v>
                </c:pt>
                <c:pt idx="29">
                  <c:v>0.863542031396626</c:v>
                </c:pt>
                <c:pt idx="30">
                  <c:v>0.76277675357977404</c:v>
                </c:pt>
                <c:pt idx="31">
                  <c:v>0.76200181692816205</c:v>
                </c:pt>
                <c:pt idx="32">
                  <c:v>0.85757153742919601</c:v>
                </c:pt>
                <c:pt idx="33">
                  <c:v>0.81204855004393395</c:v>
                </c:pt>
                <c:pt idx="34">
                  <c:v>0.79685955297311295</c:v>
                </c:pt>
                <c:pt idx="35">
                  <c:v>0.88616938890812003</c:v>
                </c:pt>
                <c:pt idx="36">
                  <c:v>0.68184389715390203</c:v>
                </c:pt>
                <c:pt idx="37">
                  <c:v>0.81417297798503496</c:v>
                </c:pt>
                <c:pt idx="38">
                  <c:v>0.86429277615639699</c:v>
                </c:pt>
                <c:pt idx="39">
                  <c:v>0.61173172178725099</c:v>
                </c:pt>
                <c:pt idx="40">
                  <c:v>0.76875548722590104</c:v>
                </c:pt>
                <c:pt idx="41">
                  <c:v>0.75190577615139698</c:v>
                </c:pt>
                <c:pt idx="42">
                  <c:v>0.71028621905812095</c:v>
                </c:pt>
                <c:pt idx="43">
                  <c:v>0.84938902741171995</c:v>
                </c:pt>
                <c:pt idx="44">
                  <c:v>0.81217169544976597</c:v>
                </c:pt>
                <c:pt idx="45">
                  <c:v>0.73988638865311596</c:v>
                </c:pt>
                <c:pt idx="46">
                  <c:v>0.62682683030786102</c:v>
                </c:pt>
                <c:pt idx="47">
                  <c:v>0.85305415500725801</c:v>
                </c:pt>
                <c:pt idx="48">
                  <c:v>0.82944020355398296</c:v>
                </c:pt>
                <c:pt idx="49">
                  <c:v>0.55251006372798595</c:v>
                </c:pt>
                <c:pt idx="50">
                  <c:v>0.56599775384024797</c:v>
                </c:pt>
                <c:pt idx="51">
                  <c:v>0.86126607612813899</c:v>
                </c:pt>
                <c:pt idx="52">
                  <c:v>0.91373470342099905</c:v>
                </c:pt>
                <c:pt idx="53">
                  <c:v>0.85997046781352504</c:v>
                </c:pt>
                <c:pt idx="54">
                  <c:v>0.79758803008184298</c:v>
                </c:pt>
                <c:pt idx="55">
                  <c:v>0.73152757655747003</c:v>
                </c:pt>
                <c:pt idx="56">
                  <c:v>0.88254080112659505</c:v>
                </c:pt>
                <c:pt idx="57">
                  <c:v>0.67022462993209198</c:v>
                </c:pt>
                <c:pt idx="58">
                  <c:v>0.81443653928968895</c:v>
                </c:pt>
                <c:pt idx="59">
                  <c:v>0.78774593582795405</c:v>
                </c:pt>
                <c:pt idx="60">
                  <c:v>0.46265479157599398</c:v>
                </c:pt>
                <c:pt idx="61">
                  <c:v>0.813316990632866</c:v>
                </c:pt>
                <c:pt idx="62">
                  <c:v>0.89155552254960901</c:v>
                </c:pt>
                <c:pt idx="63">
                  <c:v>0.49063413857990501</c:v>
                </c:pt>
                <c:pt idx="64">
                  <c:v>0.78359653006015395</c:v>
                </c:pt>
                <c:pt idx="65">
                  <c:v>0.61713479933384496</c:v>
                </c:pt>
                <c:pt idx="66">
                  <c:v>0.83223074601519997</c:v>
                </c:pt>
                <c:pt idx="67">
                  <c:v>0.64240468609772094</c:v>
                </c:pt>
                <c:pt idx="68">
                  <c:v>0.68352684741482495</c:v>
                </c:pt>
                <c:pt idx="69">
                  <c:v>0.68786177306812302</c:v>
                </c:pt>
                <c:pt idx="70">
                  <c:v>0.79268355899101095</c:v>
                </c:pt>
                <c:pt idx="71">
                  <c:v>0.65853469223660599</c:v>
                </c:pt>
                <c:pt idx="72">
                  <c:v>0.831279108890708</c:v>
                </c:pt>
                <c:pt idx="73">
                  <c:v>0.91548101672611804</c:v>
                </c:pt>
                <c:pt idx="74">
                  <c:v>0.55618351266489097</c:v>
                </c:pt>
                <c:pt idx="75">
                  <c:v>0.79392087809850498</c:v>
                </c:pt>
                <c:pt idx="76">
                  <c:v>0.84027370603149498</c:v>
                </c:pt>
                <c:pt idx="77">
                  <c:v>0.635943980919778</c:v>
                </c:pt>
                <c:pt idx="78">
                  <c:v>0.76459320044560397</c:v>
                </c:pt>
                <c:pt idx="79">
                  <c:v>0.81196251820090204</c:v>
                </c:pt>
                <c:pt idx="80">
                  <c:v>0.88610333427708499</c:v>
                </c:pt>
                <c:pt idx="81">
                  <c:v>0.749259839122562</c:v>
                </c:pt>
                <c:pt idx="82">
                  <c:v>0.88557822377393103</c:v>
                </c:pt>
                <c:pt idx="83">
                  <c:v>0.85007936868501499</c:v>
                </c:pt>
                <c:pt idx="84">
                  <c:v>0.80207773506398605</c:v>
                </c:pt>
                <c:pt idx="85">
                  <c:v>0.83198641846026</c:v>
                </c:pt>
                <c:pt idx="86">
                  <c:v>0.87621578507043096</c:v>
                </c:pt>
                <c:pt idx="87">
                  <c:v>0.80505303830106401</c:v>
                </c:pt>
                <c:pt idx="88">
                  <c:v>0.82614060496819797</c:v>
                </c:pt>
                <c:pt idx="89">
                  <c:v>0.70046197433786195</c:v>
                </c:pt>
                <c:pt idx="90">
                  <c:v>0.86940414236485697</c:v>
                </c:pt>
                <c:pt idx="91">
                  <c:v>0.83730969565504498</c:v>
                </c:pt>
                <c:pt idx="92">
                  <c:v>0.77857363911124999</c:v>
                </c:pt>
                <c:pt idx="93">
                  <c:v>0.67528851155334102</c:v>
                </c:pt>
                <c:pt idx="94">
                  <c:v>0.64362374340390405</c:v>
                </c:pt>
                <c:pt idx="95">
                  <c:v>0.92584281062559903</c:v>
                </c:pt>
                <c:pt idx="96">
                  <c:v>0.88131326829673795</c:v>
                </c:pt>
                <c:pt idx="97">
                  <c:v>0.83352900717872602</c:v>
                </c:pt>
                <c:pt idx="98">
                  <c:v>0.69848153864144003</c:v>
                </c:pt>
                <c:pt idx="99">
                  <c:v>0.83238803016413698</c:v>
                </c:pt>
                <c:pt idx="100">
                  <c:v>0.55490557900979998</c:v>
                </c:pt>
                <c:pt idx="101">
                  <c:v>0.68792239788368403</c:v>
                </c:pt>
                <c:pt idx="102">
                  <c:v>0.75583714958314296</c:v>
                </c:pt>
                <c:pt idx="103">
                  <c:v>0.64889745011228195</c:v>
                </c:pt>
                <c:pt idx="104">
                  <c:v>0.88008648204544404</c:v>
                </c:pt>
                <c:pt idx="105">
                  <c:v>0.55062436598090703</c:v>
                </c:pt>
                <c:pt idx="106">
                  <c:v>0.824022144473748</c:v>
                </c:pt>
                <c:pt idx="107">
                  <c:v>0.74284045579374303</c:v>
                </c:pt>
                <c:pt idx="108">
                  <c:v>0.71417945317279397</c:v>
                </c:pt>
                <c:pt idx="109">
                  <c:v>0.69329718897757497</c:v>
                </c:pt>
                <c:pt idx="110">
                  <c:v>0.74992974138373703</c:v>
                </c:pt>
                <c:pt idx="111">
                  <c:v>0.41229297409690702</c:v>
                </c:pt>
                <c:pt idx="112">
                  <c:v>0.86320967858894904</c:v>
                </c:pt>
                <c:pt idx="113">
                  <c:v>0.92482911990900596</c:v>
                </c:pt>
                <c:pt idx="114">
                  <c:v>0.80691546233878197</c:v>
                </c:pt>
                <c:pt idx="115">
                  <c:v>0.69719754870818496</c:v>
                </c:pt>
                <c:pt idx="116">
                  <c:v>0.83541364922599404</c:v>
                </c:pt>
                <c:pt idx="117">
                  <c:v>0.86115313534504501</c:v>
                </c:pt>
                <c:pt idx="118">
                  <c:v>0.69781264348404504</c:v>
                </c:pt>
                <c:pt idx="119">
                  <c:v>0.88379264565705795</c:v>
                </c:pt>
                <c:pt idx="120">
                  <c:v>0.72900531654143896</c:v>
                </c:pt>
                <c:pt idx="121">
                  <c:v>0.79073670188091505</c:v>
                </c:pt>
                <c:pt idx="122">
                  <c:v>0.81523492328329406</c:v>
                </c:pt>
                <c:pt idx="123">
                  <c:v>0.69907347280600296</c:v>
                </c:pt>
                <c:pt idx="124">
                  <c:v>0.91310894388872299</c:v>
                </c:pt>
                <c:pt idx="125">
                  <c:v>0.64552338646728302</c:v>
                </c:pt>
                <c:pt idx="126">
                  <c:v>0.55332317234449302</c:v>
                </c:pt>
                <c:pt idx="127">
                  <c:v>0.86108568458694601</c:v>
                </c:pt>
                <c:pt idx="128">
                  <c:v>0.75455210277638096</c:v>
                </c:pt>
                <c:pt idx="129">
                  <c:v>0.90177982822819103</c:v>
                </c:pt>
                <c:pt idx="130">
                  <c:v>0.62156053390863997</c:v>
                </c:pt>
                <c:pt idx="131">
                  <c:v>0.52522110259368704</c:v>
                </c:pt>
                <c:pt idx="132">
                  <c:v>0.78777862882179295</c:v>
                </c:pt>
                <c:pt idx="133">
                  <c:v>0.91497769461895795</c:v>
                </c:pt>
                <c:pt idx="134">
                  <c:v>0.74878318031668101</c:v>
                </c:pt>
                <c:pt idx="135">
                  <c:v>0.73230199520532502</c:v>
                </c:pt>
                <c:pt idx="136">
                  <c:v>0.77668736666656502</c:v>
                </c:pt>
                <c:pt idx="137">
                  <c:v>0.69829351447042398</c:v>
                </c:pt>
                <c:pt idx="138">
                  <c:v>0.57509836382216695</c:v>
                </c:pt>
                <c:pt idx="139">
                  <c:v>0.81759611415372502</c:v>
                </c:pt>
                <c:pt idx="140">
                  <c:v>0.79353823291944803</c:v>
                </c:pt>
                <c:pt idx="141">
                  <c:v>0.68122385703695698</c:v>
                </c:pt>
                <c:pt idx="142">
                  <c:v>0.63402409473083798</c:v>
                </c:pt>
                <c:pt idx="143">
                  <c:v>0.78179852103482805</c:v>
                </c:pt>
                <c:pt idx="144">
                  <c:v>0.78483904224615797</c:v>
                </c:pt>
                <c:pt idx="145">
                  <c:v>0.72039169077296406</c:v>
                </c:pt>
                <c:pt idx="146">
                  <c:v>0.81169899147239</c:v>
                </c:pt>
                <c:pt idx="147">
                  <c:v>0.81365929920476698</c:v>
                </c:pt>
                <c:pt idx="148">
                  <c:v>0.84870041674624597</c:v>
                </c:pt>
                <c:pt idx="149">
                  <c:v>0.61707418237387801</c:v>
                </c:pt>
                <c:pt idx="150">
                  <c:v>0.51284569070464903</c:v>
                </c:pt>
                <c:pt idx="151">
                  <c:v>0.79748231958335203</c:v>
                </c:pt>
                <c:pt idx="152">
                  <c:v>0.44300144474221897</c:v>
                </c:pt>
                <c:pt idx="153">
                  <c:v>0.75527540792036496</c:v>
                </c:pt>
                <c:pt idx="154">
                  <c:v>0.75395146353723197</c:v>
                </c:pt>
                <c:pt idx="155">
                  <c:v>0.47590664353140699</c:v>
                </c:pt>
                <c:pt idx="156">
                  <c:v>0.86074639399892305</c:v>
                </c:pt>
                <c:pt idx="157">
                  <c:v>0.80786671943650401</c:v>
                </c:pt>
                <c:pt idx="158">
                  <c:v>0.640461855215127</c:v>
                </c:pt>
                <c:pt idx="159">
                  <c:v>0.78489846543486497</c:v>
                </c:pt>
                <c:pt idx="160">
                  <c:v>0.66231547547257796</c:v>
                </c:pt>
                <c:pt idx="161">
                  <c:v>0.68631776976508196</c:v>
                </c:pt>
                <c:pt idx="162">
                  <c:v>0.74199265667173298</c:v>
                </c:pt>
                <c:pt idx="163">
                  <c:v>0.38525094938516702</c:v>
                </c:pt>
                <c:pt idx="164">
                  <c:v>0.38531322430334902</c:v>
                </c:pt>
                <c:pt idx="165">
                  <c:v>0.458331345356912</c:v>
                </c:pt>
                <c:pt idx="166">
                  <c:v>0.86395766345958602</c:v>
                </c:pt>
                <c:pt idx="167">
                  <c:v>0.44259924003947898</c:v>
                </c:pt>
                <c:pt idx="168">
                  <c:v>0.47909451887052901</c:v>
                </c:pt>
                <c:pt idx="169">
                  <c:v>0.47243832716756401</c:v>
                </c:pt>
                <c:pt idx="170">
                  <c:v>0.69517010395939305</c:v>
                </c:pt>
                <c:pt idx="171">
                  <c:v>0.83445699113306104</c:v>
                </c:pt>
                <c:pt idx="172">
                  <c:v>0.47954905600433501</c:v>
                </c:pt>
                <c:pt idx="173">
                  <c:v>0.62702535104028501</c:v>
                </c:pt>
                <c:pt idx="174">
                  <c:v>0.72723677279599197</c:v>
                </c:pt>
                <c:pt idx="175">
                  <c:v>0.61167958114371901</c:v>
                </c:pt>
                <c:pt idx="176">
                  <c:v>0.51620472340665802</c:v>
                </c:pt>
                <c:pt idx="177">
                  <c:v>0.67488672022178997</c:v>
                </c:pt>
                <c:pt idx="178">
                  <c:v>0.33417456716972799</c:v>
                </c:pt>
                <c:pt idx="179">
                  <c:v>0.48574043748616103</c:v>
                </c:pt>
                <c:pt idx="180">
                  <c:v>0.55645569145367102</c:v>
                </c:pt>
              </c:numCache>
            </c:numRef>
          </c:xVal>
          <c:yVal>
            <c:numRef>
              <c:f>'geneInfo-1301Power6Cut025-2-cop'!$F$294:$F$474</c:f>
              <c:numCache>
                <c:formatCode>General</c:formatCode>
                <c:ptCount val="181"/>
                <c:pt idx="0">
                  <c:v>0.75349974280488397</c:v>
                </c:pt>
                <c:pt idx="1">
                  <c:v>0.74121125218762995</c:v>
                </c:pt>
                <c:pt idx="2">
                  <c:v>0.73961343678601699</c:v>
                </c:pt>
                <c:pt idx="3">
                  <c:v>0.71649392833731695</c:v>
                </c:pt>
                <c:pt idx="4">
                  <c:v>0.71245312827518104</c:v>
                </c:pt>
                <c:pt idx="5">
                  <c:v>0.69265337853232201</c:v>
                </c:pt>
                <c:pt idx="6">
                  <c:v>0.69216670697779703</c:v>
                </c:pt>
                <c:pt idx="7">
                  <c:v>0.68838935208868801</c:v>
                </c:pt>
                <c:pt idx="8">
                  <c:v>0.68793687124405301</c:v>
                </c:pt>
                <c:pt idx="9">
                  <c:v>0.66332437814578504</c:v>
                </c:pt>
                <c:pt idx="10">
                  <c:v>0.661013714900062</c:v>
                </c:pt>
                <c:pt idx="11">
                  <c:v>0.64688410476270597</c:v>
                </c:pt>
                <c:pt idx="12">
                  <c:v>0.642501615002951</c:v>
                </c:pt>
                <c:pt idx="13">
                  <c:v>0.63972596553757499</c:v>
                </c:pt>
                <c:pt idx="14">
                  <c:v>0.635621966761026</c:v>
                </c:pt>
                <c:pt idx="15">
                  <c:v>0.63276073860871596</c:v>
                </c:pt>
                <c:pt idx="16">
                  <c:v>0.63152009416719401</c:v>
                </c:pt>
                <c:pt idx="17">
                  <c:v>0.63003164869052197</c:v>
                </c:pt>
                <c:pt idx="18">
                  <c:v>0.623275117134232</c:v>
                </c:pt>
                <c:pt idx="19">
                  <c:v>0.62287882030460096</c:v>
                </c:pt>
                <c:pt idx="20">
                  <c:v>0.61964806844264797</c:v>
                </c:pt>
                <c:pt idx="21">
                  <c:v>0.61730388442047601</c:v>
                </c:pt>
                <c:pt idx="22">
                  <c:v>0.61468811275434798</c:v>
                </c:pt>
                <c:pt idx="23">
                  <c:v>0.60790293462943601</c:v>
                </c:pt>
                <c:pt idx="24">
                  <c:v>0.60700659151286296</c:v>
                </c:pt>
                <c:pt idx="25">
                  <c:v>0.59268933379327304</c:v>
                </c:pt>
                <c:pt idx="26">
                  <c:v>0.59126537390821299</c:v>
                </c:pt>
                <c:pt idx="27">
                  <c:v>0.59117725370806196</c:v>
                </c:pt>
                <c:pt idx="28">
                  <c:v>0.58760256744524397</c:v>
                </c:pt>
                <c:pt idx="29">
                  <c:v>0.58694502472704702</c:v>
                </c:pt>
                <c:pt idx="30">
                  <c:v>0.58615866381026804</c:v>
                </c:pt>
                <c:pt idx="31">
                  <c:v>0.58464182738792703</c:v>
                </c:pt>
                <c:pt idx="32">
                  <c:v>0.584448566065224</c:v>
                </c:pt>
                <c:pt idx="33">
                  <c:v>0.58423800846168805</c:v>
                </c:pt>
                <c:pt idx="34">
                  <c:v>0.58204538040891296</c:v>
                </c:pt>
                <c:pt idx="35">
                  <c:v>0.58105655965905001</c:v>
                </c:pt>
                <c:pt idx="36">
                  <c:v>0.57774256194933704</c:v>
                </c:pt>
                <c:pt idx="37">
                  <c:v>0.57425928714966201</c:v>
                </c:pt>
                <c:pt idx="38">
                  <c:v>0.56981420653864301</c:v>
                </c:pt>
                <c:pt idx="39">
                  <c:v>0.56802835835013499</c:v>
                </c:pt>
                <c:pt idx="40">
                  <c:v>0.56797633136298098</c:v>
                </c:pt>
                <c:pt idx="41">
                  <c:v>0.564611370356634</c:v>
                </c:pt>
                <c:pt idx="42">
                  <c:v>0.564549757114572</c:v>
                </c:pt>
                <c:pt idx="43">
                  <c:v>0.563213716610935</c:v>
                </c:pt>
                <c:pt idx="44">
                  <c:v>0.56123429023708704</c:v>
                </c:pt>
                <c:pt idx="45">
                  <c:v>0.55756290393891506</c:v>
                </c:pt>
                <c:pt idx="46">
                  <c:v>0.55630399235111505</c:v>
                </c:pt>
                <c:pt idx="47">
                  <c:v>0.55602088255071802</c:v>
                </c:pt>
                <c:pt idx="48">
                  <c:v>0.55578264855175896</c:v>
                </c:pt>
                <c:pt idx="49">
                  <c:v>0.54954577891368805</c:v>
                </c:pt>
                <c:pt idx="50">
                  <c:v>0.54823699240527501</c:v>
                </c:pt>
                <c:pt idx="51">
                  <c:v>0.54747512205400595</c:v>
                </c:pt>
                <c:pt idx="52">
                  <c:v>0.54678011447922403</c:v>
                </c:pt>
                <c:pt idx="53">
                  <c:v>0.54454738358098698</c:v>
                </c:pt>
                <c:pt idx="54">
                  <c:v>0.53161581283438097</c:v>
                </c:pt>
                <c:pt idx="55">
                  <c:v>0.52859984546355299</c:v>
                </c:pt>
                <c:pt idx="56">
                  <c:v>0.52660577269444397</c:v>
                </c:pt>
                <c:pt idx="57">
                  <c:v>0.52210953916345404</c:v>
                </c:pt>
                <c:pt idx="58">
                  <c:v>0.52168254630660005</c:v>
                </c:pt>
                <c:pt idx="59">
                  <c:v>0.52131825856387803</c:v>
                </c:pt>
                <c:pt idx="60">
                  <c:v>0.51886100065014495</c:v>
                </c:pt>
                <c:pt idx="61">
                  <c:v>0.51211137533393103</c:v>
                </c:pt>
                <c:pt idx="62">
                  <c:v>0.51097583068605401</c:v>
                </c:pt>
                <c:pt idx="63">
                  <c:v>0.51055354218731896</c:v>
                </c:pt>
                <c:pt idx="64">
                  <c:v>0.50974118902274601</c:v>
                </c:pt>
                <c:pt idx="65">
                  <c:v>0.50781466699493005</c:v>
                </c:pt>
                <c:pt idx="66">
                  <c:v>0.50244950476232797</c:v>
                </c:pt>
                <c:pt idx="67">
                  <c:v>0.50230780946904297</c:v>
                </c:pt>
                <c:pt idx="68">
                  <c:v>0.49926804181399698</c:v>
                </c:pt>
                <c:pt idx="69">
                  <c:v>0.499050608656749</c:v>
                </c:pt>
                <c:pt idx="70">
                  <c:v>0.49838144151319502</c:v>
                </c:pt>
                <c:pt idx="71">
                  <c:v>0.49544331987130702</c:v>
                </c:pt>
                <c:pt idx="72">
                  <c:v>0.49472921783673501</c:v>
                </c:pt>
                <c:pt idx="73">
                  <c:v>0.49002028285170002</c:v>
                </c:pt>
                <c:pt idx="74">
                  <c:v>0.48944376526494598</c:v>
                </c:pt>
                <c:pt idx="75">
                  <c:v>0.48916287121754898</c:v>
                </c:pt>
                <c:pt idx="76">
                  <c:v>0.48775317315940298</c:v>
                </c:pt>
                <c:pt idx="77">
                  <c:v>0.48650107470975301</c:v>
                </c:pt>
                <c:pt idx="78">
                  <c:v>0.484059269875184</c:v>
                </c:pt>
                <c:pt idx="79">
                  <c:v>0.48261089902626297</c:v>
                </c:pt>
                <c:pt idx="80">
                  <c:v>0.48052474731118</c:v>
                </c:pt>
                <c:pt idx="81">
                  <c:v>0.47843742677903101</c:v>
                </c:pt>
                <c:pt idx="82">
                  <c:v>0.47764241103635002</c:v>
                </c:pt>
                <c:pt idx="83">
                  <c:v>0.47716593793835299</c:v>
                </c:pt>
                <c:pt idx="84">
                  <c:v>0.47517620072309602</c:v>
                </c:pt>
                <c:pt idx="85">
                  <c:v>0.47425024964169099</c:v>
                </c:pt>
                <c:pt idx="86">
                  <c:v>0.47262144060672101</c:v>
                </c:pt>
                <c:pt idx="87">
                  <c:v>0.47231820684105602</c:v>
                </c:pt>
                <c:pt idx="88">
                  <c:v>0.47001974289385001</c:v>
                </c:pt>
                <c:pt idx="89">
                  <c:v>0.468060881202296</c:v>
                </c:pt>
                <c:pt idx="90">
                  <c:v>0.46511441049498498</c:v>
                </c:pt>
                <c:pt idx="91">
                  <c:v>0.464386534198024</c:v>
                </c:pt>
                <c:pt idx="92">
                  <c:v>0.46332635932365701</c:v>
                </c:pt>
                <c:pt idx="93">
                  <c:v>0.46305567788659402</c:v>
                </c:pt>
                <c:pt idx="94">
                  <c:v>0.46183883817905802</c:v>
                </c:pt>
                <c:pt idx="95">
                  <c:v>0.46147438512053401</c:v>
                </c:pt>
                <c:pt idx="96">
                  <c:v>0.46114185944160002</c:v>
                </c:pt>
                <c:pt idx="97">
                  <c:v>0.46023228537075</c:v>
                </c:pt>
                <c:pt idx="98">
                  <c:v>0.45735466551237902</c:v>
                </c:pt>
                <c:pt idx="99">
                  <c:v>0.45735214353810999</c:v>
                </c:pt>
                <c:pt idx="100">
                  <c:v>0.45296032619417598</c:v>
                </c:pt>
                <c:pt idx="101">
                  <c:v>0.45146804442949101</c:v>
                </c:pt>
                <c:pt idx="102">
                  <c:v>0.45086952654715301</c:v>
                </c:pt>
                <c:pt idx="103">
                  <c:v>0.44991838840405002</c:v>
                </c:pt>
                <c:pt idx="104">
                  <c:v>0.44871745934909002</c:v>
                </c:pt>
                <c:pt idx="105">
                  <c:v>0.443727423899621</c:v>
                </c:pt>
                <c:pt idx="106">
                  <c:v>0.44072707863384603</c:v>
                </c:pt>
                <c:pt idx="107">
                  <c:v>0.44058051360711598</c:v>
                </c:pt>
                <c:pt idx="108">
                  <c:v>0.42935459974229601</c:v>
                </c:pt>
                <c:pt idx="109">
                  <c:v>0.42934517372616798</c:v>
                </c:pt>
                <c:pt idx="110">
                  <c:v>0.42871694303184299</c:v>
                </c:pt>
                <c:pt idx="111">
                  <c:v>0.42023637213690002</c:v>
                </c:pt>
                <c:pt idx="112">
                  <c:v>0.41862735719916</c:v>
                </c:pt>
                <c:pt idx="113">
                  <c:v>0.41642599616457698</c:v>
                </c:pt>
                <c:pt idx="114">
                  <c:v>0.41569013541026301</c:v>
                </c:pt>
                <c:pt idx="115">
                  <c:v>0.414942067074343</c:v>
                </c:pt>
                <c:pt idx="116">
                  <c:v>0.41348528281195801</c:v>
                </c:pt>
                <c:pt idx="117">
                  <c:v>0.413102422213872</c:v>
                </c:pt>
                <c:pt idx="118">
                  <c:v>0.41290987831275699</c:v>
                </c:pt>
                <c:pt idx="119">
                  <c:v>0.40889177020673501</c:v>
                </c:pt>
                <c:pt idx="120">
                  <c:v>0.408604861065896</c:v>
                </c:pt>
                <c:pt idx="121">
                  <c:v>0.405659796763713</c:v>
                </c:pt>
                <c:pt idx="122">
                  <c:v>0.40396932307112199</c:v>
                </c:pt>
                <c:pt idx="123">
                  <c:v>0.39667717935443803</c:v>
                </c:pt>
                <c:pt idx="124">
                  <c:v>0.39647841655251198</c:v>
                </c:pt>
                <c:pt idx="125">
                  <c:v>0.39503533758394299</c:v>
                </c:pt>
                <c:pt idx="126">
                  <c:v>0.39454620996019002</c:v>
                </c:pt>
                <c:pt idx="127">
                  <c:v>0.39331837745875098</c:v>
                </c:pt>
                <c:pt idx="128">
                  <c:v>0.392533171126213</c:v>
                </c:pt>
                <c:pt idx="129">
                  <c:v>0.39253059002441698</c:v>
                </c:pt>
                <c:pt idx="130">
                  <c:v>0.38741643487475802</c:v>
                </c:pt>
                <c:pt idx="131">
                  <c:v>0.38417441409693398</c:v>
                </c:pt>
                <c:pt idx="132">
                  <c:v>0.38405220057622003</c:v>
                </c:pt>
                <c:pt idx="133">
                  <c:v>0.37663608877291699</c:v>
                </c:pt>
                <c:pt idx="134">
                  <c:v>0.374954635372308</c:v>
                </c:pt>
                <c:pt idx="135">
                  <c:v>0.37424999458022201</c:v>
                </c:pt>
                <c:pt idx="136">
                  <c:v>0.373414600445171</c:v>
                </c:pt>
                <c:pt idx="137">
                  <c:v>0.37188520428879301</c:v>
                </c:pt>
                <c:pt idx="138">
                  <c:v>0.36810404469893498</c:v>
                </c:pt>
                <c:pt idx="139">
                  <c:v>0.36187859695159902</c:v>
                </c:pt>
                <c:pt idx="140">
                  <c:v>0.36110320253134798</c:v>
                </c:pt>
                <c:pt idx="141">
                  <c:v>0.35825104030322302</c:v>
                </c:pt>
                <c:pt idx="142">
                  <c:v>0.35759596660196202</c:v>
                </c:pt>
                <c:pt idx="143">
                  <c:v>0.35624133114063999</c:v>
                </c:pt>
                <c:pt idx="144">
                  <c:v>0.35340200808863498</c:v>
                </c:pt>
                <c:pt idx="145">
                  <c:v>0.348461258857652</c:v>
                </c:pt>
                <c:pt idx="146">
                  <c:v>0.34698451646233902</c:v>
                </c:pt>
                <c:pt idx="147">
                  <c:v>0.346492614465361</c:v>
                </c:pt>
                <c:pt idx="148">
                  <c:v>0.34206025894023401</c:v>
                </c:pt>
                <c:pt idx="149">
                  <c:v>0.32856089993952198</c:v>
                </c:pt>
                <c:pt idx="150">
                  <c:v>0.325934534591306</c:v>
                </c:pt>
                <c:pt idx="151">
                  <c:v>0.319290308845529</c:v>
                </c:pt>
                <c:pt idx="152">
                  <c:v>0.31203369449917301</c:v>
                </c:pt>
                <c:pt idx="153">
                  <c:v>0.29979850127038499</c:v>
                </c:pt>
                <c:pt idx="154">
                  <c:v>0.29781094436916999</c:v>
                </c:pt>
                <c:pt idx="155">
                  <c:v>0.29122383620515102</c:v>
                </c:pt>
                <c:pt idx="156">
                  <c:v>0.28999592892548198</c:v>
                </c:pt>
                <c:pt idx="157">
                  <c:v>0.28418162982124101</c:v>
                </c:pt>
                <c:pt idx="158">
                  <c:v>0.26397561218259002</c:v>
                </c:pt>
                <c:pt idx="159">
                  <c:v>0.26004265391798398</c:v>
                </c:pt>
                <c:pt idx="160">
                  <c:v>0.25324803106073701</c:v>
                </c:pt>
                <c:pt idx="161">
                  <c:v>0.25186123014498701</c:v>
                </c:pt>
                <c:pt idx="162">
                  <c:v>0.25132551958355298</c:v>
                </c:pt>
                <c:pt idx="163">
                  <c:v>0.24627448082657799</c:v>
                </c:pt>
                <c:pt idx="164">
                  <c:v>0.23339816747780201</c:v>
                </c:pt>
                <c:pt idx="165">
                  <c:v>0.22946923315712001</c:v>
                </c:pt>
                <c:pt idx="166">
                  <c:v>0.21863322569563401</c:v>
                </c:pt>
                <c:pt idx="167">
                  <c:v>0.18150038760114101</c:v>
                </c:pt>
                <c:pt idx="168">
                  <c:v>0.17819600963461801</c:v>
                </c:pt>
                <c:pt idx="169">
                  <c:v>0.16996931465144</c:v>
                </c:pt>
                <c:pt idx="170">
                  <c:v>0.16933348555915301</c:v>
                </c:pt>
                <c:pt idx="171">
                  <c:v>0.163175616317214</c:v>
                </c:pt>
                <c:pt idx="172">
                  <c:v>0.14026345181265101</c:v>
                </c:pt>
                <c:pt idx="173">
                  <c:v>0.13392815987730999</c:v>
                </c:pt>
                <c:pt idx="174">
                  <c:v>0.122348911963721</c:v>
                </c:pt>
                <c:pt idx="175">
                  <c:v>9.8130737713879701E-2</c:v>
                </c:pt>
                <c:pt idx="176">
                  <c:v>8.3390629786264797E-2</c:v>
                </c:pt>
                <c:pt idx="177">
                  <c:v>8.0669413993562297E-2</c:v>
                </c:pt>
                <c:pt idx="178">
                  <c:v>7.98701321507055E-2</c:v>
                </c:pt>
                <c:pt idx="179">
                  <c:v>4.2626252994285699E-2</c:v>
                </c:pt>
                <c:pt idx="180">
                  <c:v>3.44436854903728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4792152"/>
        <c:axId val="334792544"/>
      </c:scatterChart>
      <c:valAx>
        <c:axId val="334792152"/>
        <c:scaling>
          <c:orientation val="minMax"/>
          <c:max val="1"/>
          <c:min val="0.30000000000000004"/>
        </c:scaling>
        <c:delete val="0"/>
        <c:axPos val="b"/>
        <c:title>
          <c:tx>
            <c:rich>
              <a:bodyPr/>
              <a:lstStyle/>
              <a:p>
                <a:pPr>
                  <a:defRPr b="0"/>
                </a:pPr>
                <a:r>
                  <a:rPr lang="en-US" b="0" dirty="0" smtClean="0"/>
                  <a:t>Module membership in Brown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92544"/>
        <c:crosses val="autoZero"/>
        <c:crossBetween val="midCat"/>
      </c:valAx>
      <c:valAx>
        <c:axId val="3347925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Gene significance for malate</a:t>
                </a:r>
                <a:endParaRPr lang="en-US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34792152"/>
        <c:crossesAt val="0"/>
        <c:crossBetween val="midCat"/>
      </c:valAx>
      <c:spPr>
        <a:solidFill>
          <a:schemeClr val="bg1">
            <a:lumMod val="50000"/>
          </a:schemeClr>
        </a:solidFill>
        <a:ln w="3175"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ME-Brown</a:t>
            </a:r>
            <a:endParaRPr lang="en-US" sz="1000" dirty="0"/>
          </a:p>
        </c:rich>
      </c:tx>
      <c:layout>
        <c:manualLayout>
          <c:xMode val="edge"/>
          <c:yMode val="edge"/>
          <c:x val="7.3893115567181297E-2"/>
          <c:y val="0.2012834347001504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s (2)'!$E$1</c:f>
              <c:strCache>
                <c:ptCount val="1"/>
                <c:pt idx="0">
                  <c:v>MEblue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strRef>
              <c:f>'MEs (2)'!$C$2:$C$30</c:f>
              <c:strCache>
                <c:ptCount val="29"/>
                <c:pt idx="0">
                  <c:v>G2</c:v>
                </c:pt>
                <c:pt idx="1">
                  <c:v>G3</c:v>
                </c:pt>
                <c:pt idx="2">
                  <c:v>J1</c:v>
                </c:pt>
                <c:pt idx="3">
                  <c:v>J2</c:v>
                </c:pt>
                <c:pt idx="4">
                  <c:v>J3</c:v>
                </c:pt>
                <c:pt idx="5">
                  <c:v>C1</c:v>
                </c:pt>
                <c:pt idx="6">
                  <c:v>C2</c:v>
                </c:pt>
                <c:pt idx="7">
                  <c:v>C3</c:v>
                </c:pt>
                <c:pt idx="8">
                  <c:v>E1</c:v>
                </c:pt>
                <c:pt idx="9">
                  <c:v>E2</c:v>
                </c:pt>
                <c:pt idx="10">
                  <c:v>E3</c:v>
                </c:pt>
                <c:pt idx="11">
                  <c:v>R1</c:v>
                </c:pt>
                <c:pt idx="12">
                  <c:v>R2</c:v>
                </c:pt>
                <c:pt idx="13">
                  <c:v>R3</c:v>
                </c:pt>
                <c:pt idx="14">
                  <c:v>F1</c:v>
                </c:pt>
                <c:pt idx="15">
                  <c:v>F2</c:v>
                </c:pt>
                <c:pt idx="16">
                  <c:v>F3</c:v>
                </c:pt>
                <c:pt idx="17">
                  <c:v>P1</c:v>
                </c:pt>
                <c:pt idx="18">
                  <c:v>P2</c:v>
                </c:pt>
                <c:pt idx="19">
                  <c:v>P3</c:v>
                </c:pt>
                <c:pt idx="20">
                  <c:v>N1</c:v>
                </c:pt>
                <c:pt idx="21">
                  <c:v>N2</c:v>
                </c:pt>
                <c:pt idx="22">
                  <c:v>N3</c:v>
                </c:pt>
                <c:pt idx="23">
                  <c:v>S1</c:v>
                </c:pt>
                <c:pt idx="24">
                  <c:v>S2</c:v>
                </c:pt>
                <c:pt idx="25">
                  <c:v>S3</c:v>
                </c:pt>
                <c:pt idx="26">
                  <c:v>B1</c:v>
                </c:pt>
                <c:pt idx="27">
                  <c:v>B2</c:v>
                </c:pt>
                <c:pt idx="28">
                  <c:v>B3</c:v>
                </c:pt>
              </c:strCache>
            </c:strRef>
          </c:cat>
          <c:val>
            <c:numRef>
              <c:f>'MEs (2)'!$F$2:$F$30</c:f>
              <c:numCache>
                <c:formatCode>General</c:formatCode>
                <c:ptCount val="29"/>
                <c:pt idx="0">
                  <c:v>0.23304015</c:v>
                </c:pt>
                <c:pt idx="1">
                  <c:v>0.13688496</c:v>
                </c:pt>
                <c:pt idx="2">
                  <c:v>0.12571160000000001</c:v>
                </c:pt>
                <c:pt idx="3">
                  <c:v>8.2430400000000001E-2</c:v>
                </c:pt>
                <c:pt idx="4">
                  <c:v>9.3563969999999996E-2</c:v>
                </c:pt>
                <c:pt idx="5">
                  <c:v>0.11409799</c:v>
                </c:pt>
                <c:pt idx="6">
                  <c:v>0.10666423999999999</c:v>
                </c:pt>
                <c:pt idx="7">
                  <c:v>5.8539809999999998E-2</c:v>
                </c:pt>
                <c:pt idx="8">
                  <c:v>0.13105117999999999</c:v>
                </c:pt>
                <c:pt idx="9">
                  <c:v>0.11297639</c:v>
                </c:pt>
                <c:pt idx="10">
                  <c:v>0.124045</c:v>
                </c:pt>
                <c:pt idx="11">
                  <c:v>0.28755095000000003</c:v>
                </c:pt>
                <c:pt idx="12">
                  <c:v>0.35334061999999999</c:v>
                </c:pt>
                <c:pt idx="13">
                  <c:v>0.28550769999999998</c:v>
                </c:pt>
                <c:pt idx="14">
                  <c:v>-9.3626280000000006E-2</c:v>
                </c:pt>
                <c:pt idx="15">
                  <c:v>-8.3215499999999998E-2</c:v>
                </c:pt>
                <c:pt idx="16">
                  <c:v>-8.7005440000000003E-2</c:v>
                </c:pt>
                <c:pt idx="17">
                  <c:v>-0.23398458999999999</c:v>
                </c:pt>
                <c:pt idx="18">
                  <c:v>-0.18380793000000001</c:v>
                </c:pt>
                <c:pt idx="19">
                  <c:v>-0.13985529999999999</c:v>
                </c:pt>
                <c:pt idx="20">
                  <c:v>-0.32352946999999999</c:v>
                </c:pt>
                <c:pt idx="21">
                  <c:v>-0.28029598</c:v>
                </c:pt>
                <c:pt idx="22">
                  <c:v>-0.28992578000000002</c:v>
                </c:pt>
                <c:pt idx="23">
                  <c:v>1.476469E-2</c:v>
                </c:pt>
                <c:pt idx="24">
                  <c:v>4.3535440000000002E-2</c:v>
                </c:pt>
                <c:pt idx="25">
                  <c:v>3.4219060000000003E-2</c:v>
                </c:pt>
                <c:pt idx="26">
                  <c:v>-0.17325726999999999</c:v>
                </c:pt>
                <c:pt idx="27">
                  <c:v>-0.23995247</c:v>
                </c:pt>
                <c:pt idx="28">
                  <c:v>-0.209468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5584728"/>
        <c:axId val="335585120"/>
      </c:barChart>
      <c:catAx>
        <c:axId val="3355847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335585120"/>
        <c:crosses val="autoZero"/>
        <c:auto val="1"/>
        <c:lblAlgn val="ctr"/>
        <c:lblOffset val="100"/>
        <c:noMultiLvlLbl val="0"/>
      </c:catAx>
      <c:valAx>
        <c:axId val="335585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355847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ME-Black</a:t>
            </a:r>
            <a:endParaRPr lang="en-US" sz="1000" dirty="0"/>
          </a:p>
        </c:rich>
      </c:tx>
      <c:layout>
        <c:manualLayout>
          <c:xMode val="edge"/>
          <c:yMode val="edge"/>
          <c:x val="8.4616693478529875E-2"/>
          <c:y val="0.1618865025906882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s (2)'!$D$1</c:f>
              <c:strCache>
                <c:ptCount val="1"/>
                <c:pt idx="0">
                  <c:v>MEblack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'MEs (2)'!$C$2:$C$30</c:f>
              <c:strCache>
                <c:ptCount val="29"/>
                <c:pt idx="0">
                  <c:v>G2</c:v>
                </c:pt>
                <c:pt idx="1">
                  <c:v>G3</c:v>
                </c:pt>
                <c:pt idx="2">
                  <c:v>J1</c:v>
                </c:pt>
                <c:pt idx="3">
                  <c:v>J2</c:v>
                </c:pt>
                <c:pt idx="4">
                  <c:v>J3</c:v>
                </c:pt>
                <c:pt idx="5">
                  <c:v>C1</c:v>
                </c:pt>
                <c:pt idx="6">
                  <c:v>C2</c:v>
                </c:pt>
                <c:pt idx="7">
                  <c:v>C3</c:v>
                </c:pt>
                <c:pt idx="8">
                  <c:v>E1</c:v>
                </c:pt>
                <c:pt idx="9">
                  <c:v>E2</c:v>
                </c:pt>
                <c:pt idx="10">
                  <c:v>E3</c:v>
                </c:pt>
                <c:pt idx="11">
                  <c:v>R1</c:v>
                </c:pt>
                <c:pt idx="12">
                  <c:v>R2</c:v>
                </c:pt>
                <c:pt idx="13">
                  <c:v>R3</c:v>
                </c:pt>
                <c:pt idx="14">
                  <c:v>F1</c:v>
                </c:pt>
                <c:pt idx="15">
                  <c:v>F2</c:v>
                </c:pt>
                <c:pt idx="16">
                  <c:v>F3</c:v>
                </c:pt>
                <c:pt idx="17">
                  <c:v>P1</c:v>
                </c:pt>
                <c:pt idx="18">
                  <c:v>P2</c:v>
                </c:pt>
                <c:pt idx="19">
                  <c:v>P3</c:v>
                </c:pt>
                <c:pt idx="20">
                  <c:v>N1</c:v>
                </c:pt>
                <c:pt idx="21">
                  <c:v>N2</c:v>
                </c:pt>
                <c:pt idx="22">
                  <c:v>N3</c:v>
                </c:pt>
                <c:pt idx="23">
                  <c:v>S1</c:v>
                </c:pt>
                <c:pt idx="24">
                  <c:v>S2</c:v>
                </c:pt>
                <c:pt idx="25">
                  <c:v>S3</c:v>
                </c:pt>
                <c:pt idx="26">
                  <c:v>B1</c:v>
                </c:pt>
                <c:pt idx="27">
                  <c:v>B2</c:v>
                </c:pt>
                <c:pt idx="28">
                  <c:v>B3</c:v>
                </c:pt>
              </c:strCache>
            </c:strRef>
          </c:cat>
          <c:val>
            <c:numRef>
              <c:f>'MEs (2)'!$D$2:$D$30</c:f>
              <c:numCache>
                <c:formatCode>General</c:formatCode>
                <c:ptCount val="29"/>
                <c:pt idx="0">
                  <c:v>0.30786954999999999</c:v>
                </c:pt>
                <c:pt idx="1">
                  <c:v>0.24520644999999999</c:v>
                </c:pt>
                <c:pt idx="2">
                  <c:v>0.18139406</c:v>
                </c:pt>
                <c:pt idx="3">
                  <c:v>0.14615085</c:v>
                </c:pt>
                <c:pt idx="4">
                  <c:v>0.13608549</c:v>
                </c:pt>
                <c:pt idx="5">
                  <c:v>-0.16555257000000001</c:v>
                </c:pt>
                <c:pt idx="6">
                  <c:v>-0.15140338</c:v>
                </c:pt>
                <c:pt idx="7">
                  <c:v>-0.17228136999999999</c:v>
                </c:pt>
                <c:pt idx="8">
                  <c:v>0.25417065</c:v>
                </c:pt>
                <c:pt idx="9">
                  <c:v>0.27225671000000001</c:v>
                </c:pt>
                <c:pt idx="10">
                  <c:v>0.29270838999999998</c:v>
                </c:pt>
                <c:pt idx="11">
                  <c:v>0.10061626</c:v>
                </c:pt>
                <c:pt idx="12">
                  <c:v>0.14026422999999999</c:v>
                </c:pt>
                <c:pt idx="13">
                  <c:v>0.14768054</c:v>
                </c:pt>
                <c:pt idx="14">
                  <c:v>5.6169759999999999E-2</c:v>
                </c:pt>
                <c:pt idx="15">
                  <c:v>7.6340660000000005E-2</c:v>
                </c:pt>
                <c:pt idx="16">
                  <c:v>4.6483360000000001E-2</c:v>
                </c:pt>
                <c:pt idx="17">
                  <c:v>-0.30789457999999997</c:v>
                </c:pt>
                <c:pt idx="18">
                  <c:v>-0.27823634000000003</c:v>
                </c:pt>
                <c:pt idx="19">
                  <c:v>-0.25999639000000002</c:v>
                </c:pt>
                <c:pt idx="20">
                  <c:v>-0.17622336999999999</c:v>
                </c:pt>
                <c:pt idx="21">
                  <c:v>-0.14751336000000001</c:v>
                </c:pt>
                <c:pt idx="22">
                  <c:v>-0.12623999999999999</c:v>
                </c:pt>
                <c:pt idx="23">
                  <c:v>-4.1422970000000003E-2</c:v>
                </c:pt>
                <c:pt idx="24">
                  <c:v>-1.638533E-2</c:v>
                </c:pt>
                <c:pt idx="25">
                  <c:v>-3.1774179999999999E-2</c:v>
                </c:pt>
                <c:pt idx="26">
                  <c:v>-0.15832027000000001</c:v>
                </c:pt>
                <c:pt idx="27">
                  <c:v>-0.18282717000000001</c:v>
                </c:pt>
                <c:pt idx="28">
                  <c:v>-0.187325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5585904"/>
        <c:axId val="335586296"/>
      </c:barChart>
      <c:catAx>
        <c:axId val="335585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335586296"/>
        <c:crosses val="autoZero"/>
        <c:auto val="1"/>
        <c:lblAlgn val="ctr"/>
        <c:lblOffset val="100"/>
        <c:noMultiLvlLbl val="0"/>
      </c:catAx>
      <c:valAx>
        <c:axId val="33558629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5859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 dirty="0" smtClean="0"/>
              <a:t>ME-Yellow</a:t>
            </a:r>
            <a:endParaRPr lang="en-US" sz="1000" dirty="0"/>
          </a:p>
        </c:rich>
      </c:tx>
      <c:layout>
        <c:manualLayout>
          <c:xMode val="edge"/>
          <c:yMode val="edge"/>
          <c:x val="7.6212040963178226E-2"/>
          <c:y val="0.1735983040132539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s (2)'!$E$1</c:f>
              <c:strCache>
                <c:ptCount val="1"/>
                <c:pt idx="0">
                  <c:v>MEblue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MEs (2)'!$C$2:$C$30</c:f>
              <c:strCache>
                <c:ptCount val="29"/>
                <c:pt idx="0">
                  <c:v>G2</c:v>
                </c:pt>
                <c:pt idx="1">
                  <c:v>G3</c:v>
                </c:pt>
                <c:pt idx="2">
                  <c:v>J1</c:v>
                </c:pt>
                <c:pt idx="3">
                  <c:v>J2</c:v>
                </c:pt>
                <c:pt idx="4">
                  <c:v>J3</c:v>
                </c:pt>
                <c:pt idx="5">
                  <c:v>C1</c:v>
                </c:pt>
                <c:pt idx="6">
                  <c:v>C2</c:v>
                </c:pt>
                <c:pt idx="7">
                  <c:v>C3</c:v>
                </c:pt>
                <c:pt idx="8">
                  <c:v>E1</c:v>
                </c:pt>
                <c:pt idx="9">
                  <c:v>E2</c:v>
                </c:pt>
                <c:pt idx="10">
                  <c:v>E3</c:v>
                </c:pt>
                <c:pt idx="11">
                  <c:v>R1</c:v>
                </c:pt>
                <c:pt idx="12">
                  <c:v>R2</c:v>
                </c:pt>
                <c:pt idx="13">
                  <c:v>R3</c:v>
                </c:pt>
                <c:pt idx="14">
                  <c:v>F1</c:v>
                </c:pt>
                <c:pt idx="15">
                  <c:v>F2</c:v>
                </c:pt>
                <c:pt idx="16">
                  <c:v>F3</c:v>
                </c:pt>
                <c:pt idx="17">
                  <c:v>P1</c:v>
                </c:pt>
                <c:pt idx="18">
                  <c:v>P2</c:v>
                </c:pt>
                <c:pt idx="19">
                  <c:v>P3</c:v>
                </c:pt>
                <c:pt idx="20">
                  <c:v>N1</c:v>
                </c:pt>
                <c:pt idx="21">
                  <c:v>N2</c:v>
                </c:pt>
                <c:pt idx="22">
                  <c:v>N3</c:v>
                </c:pt>
                <c:pt idx="23">
                  <c:v>S1</c:v>
                </c:pt>
                <c:pt idx="24">
                  <c:v>S2</c:v>
                </c:pt>
                <c:pt idx="25">
                  <c:v>S3</c:v>
                </c:pt>
                <c:pt idx="26">
                  <c:v>B1</c:v>
                </c:pt>
                <c:pt idx="27">
                  <c:v>B2</c:v>
                </c:pt>
                <c:pt idx="28">
                  <c:v>B3</c:v>
                </c:pt>
              </c:strCache>
            </c:strRef>
          </c:cat>
          <c:val>
            <c:numRef>
              <c:f>'MEs (2)'!$M$2:$M$30</c:f>
              <c:numCache>
                <c:formatCode>General</c:formatCode>
                <c:ptCount val="29"/>
                <c:pt idx="0">
                  <c:v>-0.15983633</c:v>
                </c:pt>
                <c:pt idx="1">
                  <c:v>-0.12289694</c:v>
                </c:pt>
                <c:pt idx="2">
                  <c:v>-0.24639591999999999</c:v>
                </c:pt>
                <c:pt idx="3">
                  <c:v>-0.12243063</c:v>
                </c:pt>
                <c:pt idx="4">
                  <c:v>-0.14641029</c:v>
                </c:pt>
                <c:pt idx="5">
                  <c:v>-0.12032306</c:v>
                </c:pt>
                <c:pt idx="6">
                  <c:v>-0.12606582999999999</c:v>
                </c:pt>
                <c:pt idx="7">
                  <c:v>-6.9435590000000005E-2</c:v>
                </c:pt>
                <c:pt idx="8">
                  <c:v>-4.021251E-2</c:v>
                </c:pt>
                <c:pt idx="9">
                  <c:v>-9.2041629999999999E-2</c:v>
                </c:pt>
                <c:pt idx="10">
                  <c:v>-0.14161368999999999</c:v>
                </c:pt>
                <c:pt idx="11">
                  <c:v>-3.2684350000000001E-2</c:v>
                </c:pt>
                <c:pt idx="12">
                  <c:v>-5.7722410000000002E-2</c:v>
                </c:pt>
                <c:pt idx="13">
                  <c:v>-7.972796E-2</c:v>
                </c:pt>
                <c:pt idx="14">
                  <c:v>-0.13331762</c:v>
                </c:pt>
                <c:pt idx="15">
                  <c:v>-0.16008806</c:v>
                </c:pt>
                <c:pt idx="16">
                  <c:v>-0.15478928</c:v>
                </c:pt>
                <c:pt idx="17">
                  <c:v>0.41632109</c:v>
                </c:pt>
                <c:pt idx="18">
                  <c:v>0.34871822000000002</c:v>
                </c:pt>
                <c:pt idx="19">
                  <c:v>0.26422336000000002</c:v>
                </c:pt>
                <c:pt idx="20">
                  <c:v>0.35418374000000002</c:v>
                </c:pt>
                <c:pt idx="21">
                  <c:v>0.29130247999999997</c:v>
                </c:pt>
                <c:pt idx="22">
                  <c:v>0.29297879999999998</c:v>
                </c:pt>
                <c:pt idx="23">
                  <c:v>0.13064169</c:v>
                </c:pt>
                <c:pt idx="24">
                  <c:v>8.5437769999999996E-2</c:v>
                </c:pt>
                <c:pt idx="25">
                  <c:v>9.2675300000000002E-2</c:v>
                </c:pt>
                <c:pt idx="26">
                  <c:v>-0.10685430999999999</c:v>
                </c:pt>
                <c:pt idx="27">
                  <c:v>-7.4189409999999997E-2</c:v>
                </c:pt>
                <c:pt idx="28">
                  <c:v>-8.944660999999999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5587080"/>
        <c:axId val="335587472"/>
      </c:barChart>
      <c:catAx>
        <c:axId val="335587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335587472"/>
        <c:crosses val="autoZero"/>
        <c:auto val="1"/>
        <c:lblAlgn val="ctr"/>
        <c:lblOffset val="100"/>
        <c:noMultiLvlLbl val="0"/>
      </c:catAx>
      <c:valAx>
        <c:axId val="33558747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5870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 dirty="0" smtClean="0"/>
              <a:t>ME-Blue</a:t>
            </a:r>
            <a:endParaRPr lang="en-US" sz="1000" dirty="0"/>
          </a:p>
        </c:rich>
      </c:tx>
      <c:layout>
        <c:manualLayout>
          <c:xMode val="edge"/>
          <c:yMode val="edge"/>
          <c:x val="7.6709836344511811E-2"/>
          <c:y val="0.1791619023287650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s (2)'!$D$1</c:f>
              <c:strCache>
                <c:ptCount val="1"/>
                <c:pt idx="0">
                  <c:v>MEblack</c:v>
                </c:pt>
              </c:strCache>
            </c:strRef>
          </c:tx>
          <c:spPr>
            <a:solidFill>
              <a:srgbClr val="0000FF"/>
            </a:solidFill>
          </c:spPr>
          <c:invertIfNegative val="0"/>
          <c:cat>
            <c:strRef>
              <c:f>'MEs (2)'!$C$2:$C$30</c:f>
              <c:strCache>
                <c:ptCount val="29"/>
                <c:pt idx="0">
                  <c:v>G2</c:v>
                </c:pt>
                <c:pt idx="1">
                  <c:v>G3</c:v>
                </c:pt>
                <c:pt idx="2">
                  <c:v>J1</c:v>
                </c:pt>
                <c:pt idx="3">
                  <c:v>J2</c:v>
                </c:pt>
                <c:pt idx="4">
                  <c:v>J3</c:v>
                </c:pt>
                <c:pt idx="5">
                  <c:v>C1</c:v>
                </c:pt>
                <c:pt idx="6">
                  <c:v>C2</c:v>
                </c:pt>
                <c:pt idx="7">
                  <c:v>C3</c:v>
                </c:pt>
                <c:pt idx="8">
                  <c:v>E1</c:v>
                </c:pt>
                <c:pt idx="9">
                  <c:v>E2</c:v>
                </c:pt>
                <c:pt idx="10">
                  <c:v>E3</c:v>
                </c:pt>
                <c:pt idx="11">
                  <c:v>R1</c:v>
                </c:pt>
                <c:pt idx="12">
                  <c:v>R2</c:v>
                </c:pt>
                <c:pt idx="13">
                  <c:v>R3</c:v>
                </c:pt>
                <c:pt idx="14">
                  <c:v>F1</c:v>
                </c:pt>
                <c:pt idx="15">
                  <c:v>F2</c:v>
                </c:pt>
                <c:pt idx="16">
                  <c:v>F3</c:v>
                </c:pt>
                <c:pt idx="17">
                  <c:v>P1</c:v>
                </c:pt>
                <c:pt idx="18">
                  <c:v>P2</c:v>
                </c:pt>
                <c:pt idx="19">
                  <c:v>P3</c:v>
                </c:pt>
                <c:pt idx="20">
                  <c:v>N1</c:v>
                </c:pt>
                <c:pt idx="21">
                  <c:v>N2</c:v>
                </c:pt>
                <c:pt idx="22">
                  <c:v>N3</c:v>
                </c:pt>
                <c:pt idx="23">
                  <c:v>S1</c:v>
                </c:pt>
                <c:pt idx="24">
                  <c:v>S2</c:v>
                </c:pt>
                <c:pt idx="25">
                  <c:v>S3</c:v>
                </c:pt>
                <c:pt idx="26">
                  <c:v>B1</c:v>
                </c:pt>
                <c:pt idx="27">
                  <c:v>B2</c:v>
                </c:pt>
                <c:pt idx="28">
                  <c:v>B3</c:v>
                </c:pt>
              </c:strCache>
            </c:strRef>
          </c:cat>
          <c:val>
            <c:numRef>
              <c:f>'MEs (2)'!$E$2:$E$30</c:f>
              <c:numCache>
                <c:formatCode>General</c:formatCode>
                <c:ptCount val="29"/>
                <c:pt idx="0">
                  <c:v>-7.617844E-2</c:v>
                </c:pt>
                <c:pt idx="1">
                  <c:v>-5.8211430000000002E-2</c:v>
                </c:pt>
                <c:pt idx="2">
                  <c:v>-0.14334743699999999</c:v>
                </c:pt>
                <c:pt idx="3">
                  <c:v>-7.1843033000000001E-2</c:v>
                </c:pt>
                <c:pt idx="4">
                  <c:v>-6.7392593000000001E-2</c:v>
                </c:pt>
                <c:pt idx="5">
                  <c:v>-0.14596245599999999</c:v>
                </c:pt>
                <c:pt idx="6">
                  <c:v>-0.13083367800000001</c:v>
                </c:pt>
                <c:pt idx="7">
                  <c:v>-0.119608088</c:v>
                </c:pt>
                <c:pt idx="8">
                  <c:v>-5.3682792999999999E-2</c:v>
                </c:pt>
                <c:pt idx="9">
                  <c:v>-0.10747854</c:v>
                </c:pt>
                <c:pt idx="10">
                  <c:v>-0.1440631</c:v>
                </c:pt>
                <c:pt idx="11">
                  <c:v>-0.14246341700000001</c:v>
                </c:pt>
                <c:pt idx="12">
                  <c:v>-0.14812335200000001</c:v>
                </c:pt>
                <c:pt idx="13">
                  <c:v>-0.146232056</c:v>
                </c:pt>
                <c:pt idx="14">
                  <c:v>-7.1121488999999996E-2</c:v>
                </c:pt>
                <c:pt idx="15">
                  <c:v>-9.9261395000000002E-2</c:v>
                </c:pt>
                <c:pt idx="16">
                  <c:v>-0.104696057</c:v>
                </c:pt>
                <c:pt idx="17">
                  <c:v>2.2290590999999998E-2</c:v>
                </c:pt>
                <c:pt idx="18">
                  <c:v>1.5798100999999998E-2</c:v>
                </c:pt>
                <c:pt idx="19">
                  <c:v>-2.1406398E-2</c:v>
                </c:pt>
                <c:pt idx="20">
                  <c:v>0.53314795400000004</c:v>
                </c:pt>
                <c:pt idx="21">
                  <c:v>0.38714736900000002</c:v>
                </c:pt>
                <c:pt idx="22">
                  <c:v>0.57255903799999996</c:v>
                </c:pt>
                <c:pt idx="23">
                  <c:v>6.6740562000000003E-2</c:v>
                </c:pt>
                <c:pt idx="24">
                  <c:v>9.7615629999999991E-3</c:v>
                </c:pt>
                <c:pt idx="25">
                  <c:v>4.7466497000000003E-2</c:v>
                </c:pt>
                <c:pt idx="26">
                  <c:v>5.2725625999999998E-2</c:v>
                </c:pt>
                <c:pt idx="27">
                  <c:v>7.1873369000000006E-2</c:v>
                </c:pt>
                <c:pt idx="28">
                  <c:v>7.239508000000000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5674448"/>
        <c:axId val="335674840"/>
      </c:barChart>
      <c:catAx>
        <c:axId val="3356744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txPr>
          <a:bodyPr rot="-5400000" vert="horz"/>
          <a:lstStyle/>
          <a:p>
            <a:pPr>
              <a:defRPr/>
            </a:pPr>
            <a:endParaRPr lang="en-US"/>
          </a:p>
        </c:txPr>
        <c:crossAx val="335674840"/>
        <c:crosses val="autoZero"/>
        <c:auto val="1"/>
        <c:lblAlgn val="ctr"/>
        <c:lblOffset val="100"/>
        <c:noMultiLvlLbl val="0"/>
      </c:catAx>
      <c:valAx>
        <c:axId val="33567484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crossAx val="335674448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D78651-8FB6-44F5-8BFB-89520D5BAA29}" type="datetimeFigureOut">
              <a:rPr lang="en-US" smtClean="0"/>
              <a:t>6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FB5471-24C0-49CE-9D12-F21DD23384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2730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FB5471-24C0-49CE-9D12-F21DD23384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993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143360" y="-62170"/>
            <a:ext cx="11468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Figure S1</a:t>
            </a:r>
            <a:endParaRPr lang="en-US" sz="1200" dirty="0"/>
          </a:p>
        </p:txBody>
      </p:sp>
      <p:grpSp>
        <p:nvGrpSpPr>
          <p:cNvPr id="9" name="Group 8"/>
          <p:cNvGrpSpPr/>
          <p:nvPr/>
        </p:nvGrpSpPr>
        <p:grpSpPr>
          <a:xfrm>
            <a:off x="5938110" y="-62170"/>
            <a:ext cx="2808115" cy="7039185"/>
            <a:chOff x="6165795" y="-29388"/>
            <a:chExt cx="2808115" cy="7039185"/>
          </a:xfrm>
        </p:grpSpPr>
        <p:sp>
          <p:nvSpPr>
            <p:cNvPr id="10" name="TextBox 9"/>
            <p:cNvSpPr txBox="1"/>
            <p:nvPr/>
          </p:nvSpPr>
          <p:spPr>
            <a:xfrm>
              <a:off x="6165795" y="-29388"/>
              <a:ext cx="4553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anose="02020603050405020304" pitchFamily="18" charset="0"/>
                </a:rPr>
                <a:t>(B)</a:t>
              </a:r>
              <a:endParaRPr lang="en-US" sz="1200" b="1" dirty="0">
                <a:cs typeface="Times New Roman" panose="02020603050405020304" pitchFamily="18" charset="0"/>
              </a:endParaRP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6182874" y="53968"/>
              <a:ext cx="2791036" cy="6955829"/>
              <a:chOff x="4273148" y="77726"/>
              <a:chExt cx="2791036" cy="6955829"/>
            </a:xfrm>
          </p:grpSpPr>
          <p:graphicFrame>
            <p:nvGraphicFramePr>
              <p:cNvPr id="12" name="Chart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86569287"/>
                  </p:ext>
                </p:extLst>
              </p:nvPr>
            </p:nvGraphicFramePr>
            <p:xfrm>
              <a:off x="4273148" y="77726"/>
              <a:ext cx="2791036" cy="174558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13" name="Chart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951493592"/>
                  </p:ext>
                </p:extLst>
              </p:nvPr>
            </p:nvGraphicFramePr>
            <p:xfrm>
              <a:off x="4281229" y="3561436"/>
              <a:ext cx="2776255" cy="17360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4" name="Chart 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07270519"/>
                  </p:ext>
                </p:extLst>
              </p:nvPr>
            </p:nvGraphicFramePr>
            <p:xfrm>
              <a:off x="4277945" y="5293800"/>
              <a:ext cx="2779540" cy="173975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5" name="Chart 1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78650346"/>
                  </p:ext>
                </p:extLst>
              </p:nvPr>
            </p:nvGraphicFramePr>
            <p:xfrm>
              <a:off x="4277945" y="1825951"/>
              <a:ext cx="2779540" cy="173548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6" name="Rectangle 15"/>
              <p:cNvSpPr/>
              <p:nvPr/>
            </p:nvSpPr>
            <p:spPr>
              <a:xfrm>
                <a:off x="5027370" y="5364380"/>
                <a:ext cx="1180254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dirty="0" smtClean="0"/>
                  <a:t>r=0.24; p=0.0052</a:t>
                </a:r>
                <a:endParaRPr lang="en-US" sz="1000" dirty="0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5019747" y="146161"/>
                <a:ext cx="1297838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dirty="0" smtClean="0"/>
                  <a:t>r=0.47; p=1.2E-06</a:t>
                </a:r>
                <a:endParaRPr lang="en-US" sz="1000" dirty="0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5032688" y="3637331"/>
                <a:ext cx="1133107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dirty="0" smtClean="0"/>
                  <a:t>r=0.099; p=0.17</a:t>
                </a:r>
                <a:endParaRPr lang="en-US" sz="1000" dirty="0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5027370" y="1891955"/>
                <a:ext cx="1179268" cy="24622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000" dirty="0" smtClean="0"/>
                  <a:t>r=0.42; p=4E-09</a:t>
                </a:r>
                <a:endParaRPr lang="en-US" sz="1000" dirty="0"/>
              </a:p>
            </p:txBody>
          </p:sp>
        </p:grpSp>
      </p:grpSp>
      <p:grpSp>
        <p:nvGrpSpPr>
          <p:cNvPr id="21" name="Group 20"/>
          <p:cNvGrpSpPr/>
          <p:nvPr/>
        </p:nvGrpSpPr>
        <p:grpSpPr>
          <a:xfrm>
            <a:off x="368262" y="-40904"/>
            <a:ext cx="5190373" cy="6733389"/>
            <a:chOff x="94195" y="-278189"/>
            <a:chExt cx="5190373" cy="7046569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99697306"/>
                </p:ext>
              </p:extLst>
            </p:nvPr>
          </p:nvGraphicFramePr>
          <p:xfrm>
            <a:off x="103720" y="1716990"/>
            <a:ext cx="5180848" cy="1834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83969059"/>
                </p:ext>
              </p:extLst>
            </p:nvPr>
          </p:nvGraphicFramePr>
          <p:xfrm>
            <a:off x="103720" y="241410"/>
            <a:ext cx="5171840" cy="18515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6801687"/>
                </p:ext>
              </p:extLst>
            </p:nvPr>
          </p:nvGraphicFramePr>
          <p:xfrm>
            <a:off x="94195" y="4933460"/>
            <a:ext cx="5180848" cy="1834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22990524"/>
                </p:ext>
              </p:extLst>
            </p:nvPr>
          </p:nvGraphicFramePr>
          <p:xfrm>
            <a:off x="94195" y="3247180"/>
            <a:ext cx="5171840" cy="18515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>
              <a:off x="116925" y="-278189"/>
              <a:ext cx="3850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anose="02020603050405020304" pitchFamily="18" charset="0"/>
                </a:rPr>
                <a:t>(A)</a:t>
              </a:r>
              <a:endParaRPr lang="en-US" sz="1200" b="1" dirty="0"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747737" y="442514"/>
            <a:ext cx="4705490" cy="361292"/>
            <a:chOff x="971434" y="113993"/>
            <a:chExt cx="3934194" cy="248427"/>
          </a:xfrm>
        </p:grpSpPr>
        <p:cxnSp>
          <p:nvCxnSpPr>
            <p:cNvPr id="22" name="Straight Connector 21"/>
            <p:cNvCxnSpPr/>
            <p:nvPr/>
          </p:nvCxnSpPr>
          <p:spPr>
            <a:xfrm>
              <a:off x="971434" y="288828"/>
              <a:ext cx="2310351" cy="1"/>
            </a:xfrm>
            <a:prstGeom prst="line">
              <a:avLst/>
            </a:prstGeom>
            <a:ln>
              <a:solidFill>
                <a:schemeClr val="tx1"/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3301217" y="288829"/>
              <a:ext cx="1604411" cy="1"/>
            </a:xfrm>
            <a:prstGeom prst="line">
              <a:avLst/>
            </a:prstGeom>
            <a:ln>
              <a:solidFill>
                <a:schemeClr val="tx1"/>
              </a:solidFill>
              <a:tailEnd type="oval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996481" y="113993"/>
              <a:ext cx="4355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 smtClean="0">
                  <a:cs typeface="Times New Roman" panose="02020603050405020304" pitchFamily="18" charset="0"/>
                </a:rPr>
                <a:t>Ma_</a:t>
              </a:r>
              <a:endParaRPr lang="en-US" sz="1000" i="1" dirty="0"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252891" y="116199"/>
              <a:ext cx="6417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i="1" dirty="0" smtClean="0">
                  <a:cs typeface="Times New Roman" panose="02020603050405020304" pitchFamily="18" charset="0"/>
                </a:rPr>
                <a:t>mama</a:t>
              </a:r>
              <a:endParaRPr lang="en-US" sz="1000" i="1" dirty="0"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576726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249</TotalTime>
  <Words>60</Words>
  <Application>Microsoft Office PowerPoint</Application>
  <PresentationFormat>On-screen Show 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 Bai</dc:creator>
  <cp:lastModifiedBy>Kenong Xu</cp:lastModifiedBy>
  <cp:revision>921</cp:revision>
  <cp:lastPrinted>2014-04-18T18:26:45Z</cp:lastPrinted>
  <dcterms:created xsi:type="dcterms:W3CDTF">2006-08-16T00:00:00Z</dcterms:created>
  <dcterms:modified xsi:type="dcterms:W3CDTF">2015-06-18T23:46:00Z</dcterms:modified>
</cp:coreProperties>
</file>